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05" r:id="rId2"/>
  </p:sldIdLst>
  <p:sldSz cx="6858000" cy="9906000" type="A4"/>
  <p:notesSz cx="6877050" cy="965676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0" userDrawn="1">
          <p15:clr>
            <a:srgbClr val="A4A3A4"/>
          </p15:clr>
        </p15:guide>
        <p15:guide id="2" pos="3960" userDrawn="1">
          <p15:clr>
            <a:srgbClr val="A4A3A4"/>
          </p15:clr>
        </p15:guide>
        <p15:guide id="3" orient="horz" pos="2328" userDrawn="1">
          <p15:clr>
            <a:srgbClr val="A4A3A4"/>
          </p15:clr>
        </p15:guide>
        <p15:guide id="4" pos="1797" userDrawn="1">
          <p15:clr>
            <a:srgbClr val="A4A3A4"/>
          </p15:clr>
        </p15:guide>
        <p15:guide id="5" pos="2016" userDrawn="1">
          <p15:clr>
            <a:srgbClr val="A4A3A4"/>
          </p15:clr>
        </p15:guide>
        <p15:guide id="6" pos="216" userDrawn="1">
          <p15:clr>
            <a:srgbClr val="A4A3A4"/>
          </p15:clr>
        </p15:guide>
        <p15:guide id="7" pos="2400" userDrawn="1">
          <p15:clr>
            <a:srgbClr val="A4A3A4"/>
          </p15:clr>
        </p15:guide>
        <p15:guide id="8" orient="horz" pos="3324" userDrawn="1">
          <p15:clr>
            <a:srgbClr val="A4A3A4"/>
          </p15:clr>
        </p15:guide>
        <p15:guide id="9" orient="horz" pos="1827" userDrawn="1">
          <p15:clr>
            <a:srgbClr val="A4A3A4"/>
          </p15:clr>
        </p15:guide>
        <p15:guide id="10" orient="horz" pos="852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041" userDrawn="1">
          <p15:clr>
            <a:srgbClr val="A4A3A4"/>
          </p15:clr>
        </p15:guide>
        <p15:guide id="2" pos="2166" userDrawn="1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14BCB8"/>
    <a:srgbClr val="F8F8AE"/>
    <a:srgbClr val="CBC2E4"/>
    <a:srgbClr val="6666FF"/>
    <a:srgbClr val="FF99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2343" autoAdjust="0"/>
    <p:restoredTop sz="97455" autoAdjust="0"/>
  </p:normalViewPr>
  <p:slideViewPr>
    <p:cSldViewPr snapToGrid="0" showGuides="1">
      <p:cViewPr varScale="1">
        <p:scale>
          <a:sx n="109" d="100"/>
          <a:sy n="109" d="100"/>
        </p:scale>
        <p:origin x="4248" y="108"/>
      </p:cViewPr>
      <p:guideLst>
        <p:guide orient="horz" pos="330"/>
        <p:guide pos="3960"/>
        <p:guide orient="horz" pos="2328"/>
        <p:guide pos="1797"/>
        <p:guide pos="2016"/>
        <p:guide pos="216"/>
        <p:guide pos="2400"/>
        <p:guide orient="horz" pos="3324"/>
        <p:guide orient="horz" pos="1827"/>
        <p:guide orient="horz" pos="852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 showGuides="1">
      <p:cViewPr varScale="1">
        <p:scale>
          <a:sx n="115" d="100"/>
          <a:sy n="115" d="100"/>
        </p:scale>
        <p:origin x="1224" y="102"/>
      </p:cViewPr>
      <p:guideLst>
        <p:guide orient="horz" pos="3041"/>
        <p:guide pos="2166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0055" cy="484515"/>
          </a:xfrm>
          <a:prstGeom prst="rect">
            <a:avLst/>
          </a:prstGeom>
        </p:spPr>
        <p:txBody>
          <a:bodyPr vert="horz" lIns="94476" tIns="47238" rIns="94476" bIns="47238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95404" y="0"/>
            <a:ext cx="2980055" cy="484515"/>
          </a:xfrm>
          <a:prstGeom prst="rect">
            <a:avLst/>
          </a:prstGeom>
        </p:spPr>
        <p:txBody>
          <a:bodyPr vert="horz" lIns="94476" tIns="47238" rIns="94476" bIns="47238" rtlCol="0"/>
          <a:lstStyle>
            <a:lvl1pPr algn="r">
              <a:defRPr sz="1200"/>
            </a:lvl1pPr>
          </a:lstStyle>
          <a:p>
            <a:fld id="{29F9F086-EB90-426E-A0D6-42C39696E1BD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11400" y="1206500"/>
            <a:ext cx="2254250" cy="32591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476" tIns="47238" rIns="94476" bIns="47238" rtlCol="0" anchor="ctr"/>
          <a:lstStyle/>
          <a:p>
            <a:endParaRPr lang="en-U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7705" y="4647317"/>
            <a:ext cx="5501640" cy="3802350"/>
          </a:xfrm>
          <a:prstGeom prst="rect">
            <a:avLst/>
          </a:prstGeom>
        </p:spPr>
        <p:txBody>
          <a:bodyPr vert="horz" lIns="94476" tIns="47238" rIns="94476" bIns="47238" rtlCol="0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9172249"/>
            <a:ext cx="2980055" cy="484514"/>
          </a:xfrm>
          <a:prstGeom prst="rect">
            <a:avLst/>
          </a:prstGeom>
        </p:spPr>
        <p:txBody>
          <a:bodyPr vert="horz" lIns="94476" tIns="47238" rIns="94476" bIns="47238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95404" y="9172249"/>
            <a:ext cx="2980055" cy="484514"/>
          </a:xfrm>
          <a:prstGeom prst="rect">
            <a:avLst/>
          </a:prstGeom>
        </p:spPr>
        <p:txBody>
          <a:bodyPr vert="horz" lIns="94476" tIns="47238" rIns="94476" bIns="47238" rtlCol="0" anchor="b"/>
          <a:lstStyle>
            <a:lvl1pPr algn="r">
              <a:defRPr sz="1200"/>
            </a:lvl1pPr>
          </a:lstStyle>
          <a:p>
            <a:fld id="{94E6604B-AD8E-4AF3-A73A-B92E5AA90BA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76116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4E6604B-AD8E-4AF3-A73A-B92E5AA90BA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83800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34440-0854-4AB6-A78A-FECE4C1D96B6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67C4E-1418-4B63-95DF-D267474CB4F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23811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34440-0854-4AB6-A78A-FECE4C1D96B6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67C4E-1418-4B63-95DF-D267474CB4F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27169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34440-0854-4AB6-A78A-FECE4C1D96B6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67C4E-1418-4B63-95DF-D267474CB4F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28933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34440-0854-4AB6-A78A-FECE4C1D96B6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67C4E-1418-4B63-95DF-D267474CB4F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92911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34440-0854-4AB6-A78A-FECE4C1D96B6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67C4E-1418-4B63-95DF-D267474CB4F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7426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34440-0854-4AB6-A78A-FECE4C1D96B6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67C4E-1418-4B63-95DF-D267474CB4F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67102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34440-0854-4AB6-A78A-FECE4C1D96B6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67C4E-1418-4B63-95DF-D267474CB4F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3432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34440-0854-4AB6-A78A-FECE4C1D96B6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67C4E-1418-4B63-95DF-D267474CB4F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37553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34440-0854-4AB6-A78A-FECE4C1D96B6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67C4E-1418-4B63-95DF-D267474CB4F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8056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34440-0854-4AB6-A78A-FECE4C1D96B6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67C4E-1418-4B63-95DF-D267474CB4F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66903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34440-0854-4AB6-A78A-FECE4C1D96B6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67C4E-1418-4B63-95DF-D267474CB4F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85985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434440-0854-4AB6-A78A-FECE4C1D96B6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467C4E-1418-4B63-95DF-D267474CB4F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23508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CuadroTexto 22"/>
          <p:cNvSpPr txBox="1"/>
          <p:nvPr/>
        </p:nvSpPr>
        <p:spPr>
          <a:xfrm>
            <a:off x="5651986" y="9239534"/>
            <a:ext cx="11515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Figure S1</a:t>
            </a:r>
          </a:p>
        </p:txBody>
      </p:sp>
      <p:grpSp>
        <p:nvGrpSpPr>
          <p:cNvPr id="2" name="Grupo 1">
            <a:extLst>
              <a:ext uri="{FF2B5EF4-FFF2-40B4-BE49-F238E27FC236}">
                <a16:creationId xmlns:a16="http://schemas.microsoft.com/office/drawing/2014/main" id="{5BCF5691-1E23-4BDE-992E-F921F7100F78}"/>
              </a:ext>
            </a:extLst>
          </p:cNvPr>
          <p:cNvGrpSpPr/>
          <p:nvPr/>
        </p:nvGrpSpPr>
        <p:grpSpPr>
          <a:xfrm>
            <a:off x="436852" y="1292136"/>
            <a:ext cx="5981213" cy="6741106"/>
            <a:chOff x="436852" y="1292136"/>
            <a:chExt cx="5981213" cy="6741106"/>
          </a:xfrm>
        </p:grpSpPr>
        <p:grpSp>
          <p:nvGrpSpPr>
            <p:cNvPr id="43" name="Grupo 42"/>
            <p:cNvGrpSpPr>
              <a:grpSpLocks noChangeAspect="1"/>
            </p:cNvGrpSpPr>
            <p:nvPr/>
          </p:nvGrpSpPr>
          <p:grpSpPr>
            <a:xfrm>
              <a:off x="2946425" y="1472610"/>
              <a:ext cx="3471640" cy="6334464"/>
              <a:chOff x="504754" y="634468"/>
              <a:chExt cx="2893033" cy="5278721"/>
            </a:xfrm>
          </p:grpSpPr>
          <p:grpSp>
            <p:nvGrpSpPr>
              <p:cNvPr id="44" name="Grupo 43"/>
              <p:cNvGrpSpPr/>
              <p:nvPr/>
            </p:nvGrpSpPr>
            <p:grpSpPr>
              <a:xfrm>
                <a:off x="504754" y="756593"/>
                <a:ext cx="2805020" cy="5130757"/>
                <a:chOff x="458498" y="137396"/>
                <a:chExt cx="2805020" cy="5130757"/>
              </a:xfrm>
            </p:grpSpPr>
            <p:pic>
              <p:nvPicPr>
                <p:cNvPr id="86" name="Imagen 85"/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458498" y="3593658"/>
                  <a:ext cx="2802255" cy="1674495"/>
                </a:xfrm>
                <a:prstGeom prst="rect">
                  <a:avLst/>
                </a:prstGeom>
              </p:spPr>
            </p:pic>
            <p:pic>
              <p:nvPicPr>
                <p:cNvPr id="87" name="Imagen 86"/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458499" y="1865527"/>
                  <a:ext cx="2802255" cy="1674495"/>
                </a:xfrm>
                <a:prstGeom prst="rect">
                  <a:avLst/>
                </a:prstGeom>
              </p:spPr>
            </p:pic>
            <p:pic>
              <p:nvPicPr>
                <p:cNvPr id="88" name="Imagen 87"/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461263" y="137396"/>
                  <a:ext cx="2802255" cy="1674495"/>
                </a:xfrm>
                <a:prstGeom prst="rect">
                  <a:avLst/>
                </a:prstGeom>
              </p:spPr>
            </p:pic>
          </p:grpSp>
          <p:sp>
            <p:nvSpPr>
              <p:cNvPr id="45" name="CuadroTexto 44"/>
              <p:cNvSpPr txBox="1"/>
              <p:nvPr/>
            </p:nvSpPr>
            <p:spPr>
              <a:xfrm>
                <a:off x="1944148" y="634468"/>
                <a:ext cx="720283" cy="3334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000" b="1" dirty="0">
                    <a:solidFill>
                      <a:srgbClr val="FF9900"/>
                    </a:solidFill>
                  </a:rPr>
                  <a:t>C-</a:t>
                </a:r>
                <a:r>
                  <a:rPr lang="es-ES" sz="1000" b="1" dirty="0" err="1">
                    <a:solidFill>
                      <a:srgbClr val="FF9900"/>
                    </a:solidFill>
                  </a:rPr>
                  <a:t>loop</a:t>
                </a:r>
                <a:r>
                  <a:rPr lang="es-ES" sz="1000" b="1" dirty="0">
                    <a:solidFill>
                      <a:srgbClr val="FF9900"/>
                    </a:solidFill>
                  </a:rPr>
                  <a:t> </a:t>
                </a:r>
              </a:p>
              <a:p>
                <a:pPr algn="ctr"/>
                <a:r>
                  <a:rPr lang="es-ES" sz="1000" b="1" dirty="0" err="1">
                    <a:solidFill>
                      <a:srgbClr val="FF9900"/>
                    </a:solidFill>
                  </a:rPr>
                  <a:t>WTox</a:t>
                </a:r>
                <a:r>
                  <a:rPr lang="es-ES" sz="1000" b="1" dirty="0">
                    <a:solidFill>
                      <a:srgbClr val="FF9900"/>
                    </a:solidFill>
                  </a:rPr>
                  <a:t> (4bv6)</a:t>
                </a:r>
              </a:p>
            </p:txBody>
          </p:sp>
          <p:sp>
            <p:nvSpPr>
              <p:cNvPr id="46" name="CuadroTexto 45"/>
              <p:cNvSpPr txBox="1"/>
              <p:nvPr/>
            </p:nvSpPr>
            <p:spPr>
              <a:xfrm>
                <a:off x="860425" y="1541462"/>
                <a:ext cx="352928" cy="19236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b="1" dirty="0">
                    <a:solidFill>
                      <a:srgbClr val="FF0000"/>
                    </a:solidFill>
                  </a:rPr>
                  <a:t>R201</a:t>
                </a:r>
              </a:p>
            </p:txBody>
          </p:sp>
          <p:sp>
            <p:nvSpPr>
              <p:cNvPr id="47" name="CuadroTexto 46"/>
              <p:cNvSpPr txBox="1"/>
              <p:nvPr/>
            </p:nvSpPr>
            <p:spPr>
              <a:xfrm>
                <a:off x="812402" y="1285218"/>
                <a:ext cx="384988" cy="19236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b="1" dirty="0">
                    <a:solidFill>
                      <a:srgbClr val="FF0000"/>
                    </a:solidFill>
                  </a:rPr>
                  <a:t>W196</a:t>
                </a:r>
              </a:p>
            </p:txBody>
          </p:sp>
          <p:sp>
            <p:nvSpPr>
              <p:cNvPr id="48" name="CuadroTexto 47"/>
              <p:cNvSpPr txBox="1"/>
              <p:nvPr/>
            </p:nvSpPr>
            <p:spPr>
              <a:xfrm>
                <a:off x="1186532" y="1005407"/>
                <a:ext cx="348920" cy="19236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b="1" dirty="0">
                    <a:solidFill>
                      <a:srgbClr val="7030A0"/>
                    </a:solidFill>
                  </a:rPr>
                  <a:t>P488</a:t>
                </a:r>
              </a:p>
            </p:txBody>
          </p:sp>
          <p:sp>
            <p:nvSpPr>
              <p:cNvPr id="49" name="CuadroTexto 48"/>
              <p:cNvSpPr txBox="1"/>
              <p:nvPr/>
            </p:nvSpPr>
            <p:spPr>
              <a:xfrm>
                <a:off x="2281382" y="1913791"/>
                <a:ext cx="347585" cy="19236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b="1" dirty="0">
                    <a:solidFill>
                      <a:srgbClr val="7030A0"/>
                    </a:solidFill>
                  </a:rPr>
                  <a:t>Y476</a:t>
                </a:r>
              </a:p>
            </p:txBody>
          </p:sp>
          <p:sp>
            <p:nvSpPr>
              <p:cNvPr id="50" name="CuadroTexto 49"/>
              <p:cNvSpPr txBox="1"/>
              <p:nvPr/>
            </p:nvSpPr>
            <p:spPr>
              <a:xfrm>
                <a:off x="2236853" y="1800641"/>
                <a:ext cx="343577" cy="19236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b="1" dirty="0">
                    <a:solidFill>
                      <a:srgbClr val="7030A0"/>
                    </a:solidFill>
                  </a:rPr>
                  <a:t>S480</a:t>
                </a:r>
              </a:p>
            </p:txBody>
          </p:sp>
          <p:sp>
            <p:nvSpPr>
              <p:cNvPr id="51" name="CuadroTexto 50"/>
              <p:cNvSpPr txBox="1"/>
              <p:nvPr/>
            </p:nvSpPr>
            <p:spPr>
              <a:xfrm>
                <a:off x="2223741" y="1516469"/>
                <a:ext cx="358272" cy="19236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b="1" dirty="0">
                    <a:solidFill>
                      <a:srgbClr val="7030A0"/>
                    </a:solidFill>
                  </a:rPr>
                  <a:t>H478</a:t>
                </a:r>
              </a:p>
            </p:txBody>
          </p:sp>
          <p:sp>
            <p:nvSpPr>
              <p:cNvPr id="52" name="CuadroTexto 51"/>
              <p:cNvSpPr txBox="1"/>
              <p:nvPr/>
            </p:nvSpPr>
            <p:spPr>
              <a:xfrm>
                <a:off x="2710970" y="1965998"/>
                <a:ext cx="384988" cy="19236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b="1" dirty="0">
                    <a:solidFill>
                      <a:srgbClr val="7030A0"/>
                    </a:solidFill>
                  </a:rPr>
                  <a:t>W477</a:t>
                </a:r>
              </a:p>
            </p:txBody>
          </p:sp>
          <p:sp>
            <p:nvSpPr>
              <p:cNvPr id="53" name="CuadroTexto 52"/>
              <p:cNvSpPr txBox="1"/>
              <p:nvPr/>
            </p:nvSpPr>
            <p:spPr>
              <a:xfrm>
                <a:off x="2053524" y="1980894"/>
                <a:ext cx="358272" cy="19236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b="1" dirty="0">
                    <a:solidFill>
                      <a:srgbClr val="7030A0"/>
                    </a:solidFill>
                  </a:rPr>
                  <a:t>H454</a:t>
                </a:r>
              </a:p>
            </p:txBody>
          </p:sp>
          <p:sp>
            <p:nvSpPr>
              <p:cNvPr id="54" name="CuadroTexto 53"/>
              <p:cNvSpPr txBox="1"/>
              <p:nvPr/>
            </p:nvSpPr>
            <p:spPr>
              <a:xfrm>
                <a:off x="2113915" y="2247599"/>
                <a:ext cx="358272" cy="19236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b="1" dirty="0">
                    <a:solidFill>
                      <a:srgbClr val="7030A0"/>
                    </a:solidFill>
                  </a:rPr>
                  <a:t>H457</a:t>
                </a:r>
              </a:p>
            </p:txBody>
          </p:sp>
          <p:sp>
            <p:nvSpPr>
              <p:cNvPr id="55" name="CuadroTexto 54"/>
              <p:cNvSpPr txBox="1"/>
              <p:nvPr/>
            </p:nvSpPr>
            <p:spPr>
              <a:xfrm>
                <a:off x="1253768" y="1757624"/>
                <a:ext cx="358272" cy="19236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b="1" dirty="0">
                    <a:solidFill>
                      <a:srgbClr val="7030A0"/>
                    </a:solidFill>
                  </a:rPr>
                  <a:t>H455</a:t>
                </a:r>
              </a:p>
            </p:txBody>
          </p:sp>
          <p:sp>
            <p:nvSpPr>
              <p:cNvPr id="56" name="CuadroTexto 55"/>
              <p:cNvSpPr txBox="1"/>
              <p:nvPr/>
            </p:nvSpPr>
            <p:spPr>
              <a:xfrm>
                <a:off x="1149957" y="2028502"/>
                <a:ext cx="316860" cy="19236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b="1" dirty="0">
                    <a:solidFill>
                      <a:srgbClr val="FF9900"/>
                    </a:solidFill>
                  </a:rPr>
                  <a:t>FAD</a:t>
                </a:r>
              </a:p>
            </p:txBody>
          </p:sp>
          <p:sp>
            <p:nvSpPr>
              <p:cNvPr id="57" name="CuadroTexto 56"/>
              <p:cNvSpPr txBox="1"/>
              <p:nvPr/>
            </p:nvSpPr>
            <p:spPr>
              <a:xfrm>
                <a:off x="1510466" y="1662386"/>
                <a:ext cx="384988" cy="19236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b="1" dirty="0">
                    <a:solidFill>
                      <a:srgbClr val="7030A0"/>
                    </a:solidFill>
                  </a:rPr>
                  <a:t>W483</a:t>
                </a:r>
              </a:p>
            </p:txBody>
          </p:sp>
          <p:sp>
            <p:nvSpPr>
              <p:cNvPr id="58" name="CuadroTexto 57"/>
              <p:cNvSpPr txBox="1"/>
              <p:nvPr/>
            </p:nvSpPr>
            <p:spPr>
              <a:xfrm>
                <a:off x="1358724" y="1539388"/>
                <a:ext cx="338233" cy="19236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b="1" dirty="0">
                    <a:solidFill>
                      <a:srgbClr val="7030A0"/>
                    </a:solidFill>
                  </a:rPr>
                  <a:t>L486</a:t>
                </a:r>
              </a:p>
            </p:txBody>
          </p:sp>
          <p:sp>
            <p:nvSpPr>
              <p:cNvPr id="59" name="CuadroTexto 58"/>
              <p:cNvSpPr txBox="1"/>
              <p:nvPr/>
            </p:nvSpPr>
            <p:spPr>
              <a:xfrm>
                <a:off x="1983112" y="1784075"/>
                <a:ext cx="342242" cy="19236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b="1" dirty="0">
                    <a:solidFill>
                      <a:srgbClr val="7030A0"/>
                    </a:solidFill>
                  </a:rPr>
                  <a:t>F482</a:t>
                </a:r>
              </a:p>
            </p:txBody>
          </p:sp>
          <p:sp>
            <p:nvSpPr>
              <p:cNvPr id="60" name="CuadroTexto 59"/>
              <p:cNvSpPr txBox="1"/>
              <p:nvPr/>
            </p:nvSpPr>
            <p:spPr>
              <a:xfrm>
                <a:off x="2516253" y="1118336"/>
                <a:ext cx="344913" cy="19236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b="1" dirty="0"/>
                  <a:t>E537</a:t>
                </a:r>
              </a:p>
            </p:txBody>
          </p:sp>
          <p:sp>
            <p:nvSpPr>
              <p:cNvPr id="61" name="CuadroTexto 60"/>
              <p:cNvSpPr txBox="1"/>
              <p:nvPr/>
            </p:nvSpPr>
            <p:spPr>
              <a:xfrm>
                <a:off x="2064744" y="1289524"/>
                <a:ext cx="344913" cy="19236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b="1" dirty="0"/>
                  <a:t>E535</a:t>
                </a:r>
              </a:p>
            </p:txBody>
          </p:sp>
          <p:sp>
            <p:nvSpPr>
              <p:cNvPr id="62" name="CuadroTexto 61"/>
              <p:cNvSpPr txBox="1"/>
              <p:nvPr/>
            </p:nvSpPr>
            <p:spPr>
              <a:xfrm>
                <a:off x="1882863" y="1005407"/>
                <a:ext cx="344913" cy="19236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b="1" dirty="0"/>
                  <a:t>E533</a:t>
                </a:r>
              </a:p>
            </p:txBody>
          </p:sp>
          <p:sp>
            <p:nvSpPr>
              <p:cNvPr id="63" name="CuadroTexto 62"/>
              <p:cNvSpPr txBox="1"/>
              <p:nvPr/>
            </p:nvSpPr>
            <p:spPr>
              <a:xfrm>
                <a:off x="1464467" y="1062747"/>
                <a:ext cx="352928" cy="19236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b="1" dirty="0"/>
                  <a:t>R529</a:t>
                </a:r>
              </a:p>
            </p:txBody>
          </p:sp>
          <p:sp>
            <p:nvSpPr>
              <p:cNvPr id="64" name="CuadroTexto 63"/>
              <p:cNvSpPr txBox="1"/>
              <p:nvPr/>
            </p:nvSpPr>
            <p:spPr>
              <a:xfrm>
                <a:off x="1345376" y="1289524"/>
                <a:ext cx="344913" cy="19236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b="1" dirty="0"/>
                  <a:t>E531</a:t>
                </a:r>
              </a:p>
            </p:txBody>
          </p:sp>
          <p:sp>
            <p:nvSpPr>
              <p:cNvPr id="65" name="Rectángulo 64"/>
              <p:cNvSpPr/>
              <p:nvPr/>
            </p:nvSpPr>
            <p:spPr>
              <a:xfrm>
                <a:off x="2462170" y="2270597"/>
                <a:ext cx="684216" cy="20518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 algn="ctr"/>
                <a:r>
                  <a:rPr lang="es-ES" sz="1000" b="1" dirty="0" err="1">
                    <a:solidFill>
                      <a:srgbClr val="7030A0"/>
                    </a:solidFill>
                  </a:rPr>
                  <a:t>WT</a:t>
                </a:r>
                <a:r>
                  <a:rPr lang="es-ES" sz="1000" b="1" baseline="-25000" dirty="0" err="1">
                    <a:solidFill>
                      <a:srgbClr val="7030A0"/>
                    </a:solidFill>
                  </a:rPr>
                  <a:t>ox</a:t>
                </a:r>
                <a:r>
                  <a:rPr lang="es-ES" sz="1000" b="1" dirty="0">
                    <a:solidFill>
                      <a:srgbClr val="7030A0"/>
                    </a:solidFill>
                  </a:rPr>
                  <a:t> (4bv6)</a:t>
                </a:r>
              </a:p>
            </p:txBody>
          </p:sp>
          <p:sp>
            <p:nvSpPr>
              <p:cNvPr id="66" name="Rectángulo 65"/>
              <p:cNvSpPr/>
              <p:nvPr/>
            </p:nvSpPr>
            <p:spPr>
              <a:xfrm>
                <a:off x="2542585" y="3924540"/>
                <a:ext cx="855202" cy="20518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 algn="ctr"/>
                <a:r>
                  <a:rPr lang="es-ES" sz="1000" b="1" dirty="0">
                    <a:solidFill>
                      <a:schemeClr val="bg1">
                        <a:lumMod val="65000"/>
                      </a:schemeClr>
                    </a:solidFill>
                  </a:rPr>
                  <a:t>W196A</a:t>
                </a:r>
                <a:r>
                  <a:rPr lang="es-ES" sz="1000" b="1" baseline="-25000" dirty="0">
                    <a:solidFill>
                      <a:schemeClr val="bg1">
                        <a:lumMod val="65000"/>
                      </a:schemeClr>
                    </a:solidFill>
                  </a:rPr>
                  <a:t>ox</a:t>
                </a:r>
                <a:r>
                  <a:rPr lang="es-ES" sz="1000" b="1" dirty="0">
                    <a:solidFill>
                      <a:schemeClr val="bg1">
                        <a:lumMod val="65000"/>
                      </a:schemeClr>
                    </a:solidFill>
                  </a:rPr>
                  <a:t> (5kvh)</a:t>
                </a:r>
              </a:p>
            </p:txBody>
          </p:sp>
          <p:sp>
            <p:nvSpPr>
              <p:cNvPr id="67" name="Rectángulo 66"/>
              <p:cNvSpPr/>
              <p:nvPr/>
            </p:nvSpPr>
            <p:spPr>
              <a:xfrm>
                <a:off x="2525166" y="5652671"/>
                <a:ext cx="817798" cy="20518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 algn="ctr"/>
                <a:r>
                  <a:rPr lang="es-ES" sz="1000" b="1" dirty="0">
                    <a:solidFill>
                      <a:schemeClr val="accent5">
                        <a:lumMod val="75000"/>
                      </a:schemeClr>
                    </a:solidFill>
                  </a:rPr>
                  <a:t>WT CTC (4bur)</a:t>
                </a:r>
              </a:p>
            </p:txBody>
          </p:sp>
          <p:sp>
            <p:nvSpPr>
              <p:cNvPr id="68" name="Flecha curvada hacia arriba 67"/>
              <p:cNvSpPr/>
              <p:nvPr/>
            </p:nvSpPr>
            <p:spPr>
              <a:xfrm rot="17195549">
                <a:off x="2274495" y="3273563"/>
                <a:ext cx="246062" cy="96817"/>
              </a:xfrm>
              <a:prstGeom prst="curvedUpArrow">
                <a:avLst/>
              </a:prstGeom>
              <a:solidFill>
                <a:schemeClr val="bg1">
                  <a:lumMod val="95000"/>
                </a:schemeClr>
              </a:solidFill>
              <a:ln w="6350"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2800">
                  <a:solidFill>
                    <a:schemeClr val="tx1"/>
                  </a:solidFill>
                </a:endParaRPr>
              </a:p>
            </p:txBody>
          </p:sp>
          <p:sp>
            <p:nvSpPr>
              <p:cNvPr id="69" name="Flecha curvada hacia arriba 68"/>
              <p:cNvSpPr/>
              <p:nvPr/>
            </p:nvSpPr>
            <p:spPr>
              <a:xfrm rot="17195549">
                <a:off x="2248216" y="5000768"/>
                <a:ext cx="246062" cy="96817"/>
              </a:xfrm>
              <a:prstGeom prst="curvedUpArrow">
                <a:avLst/>
              </a:prstGeom>
              <a:solidFill>
                <a:schemeClr val="bg1">
                  <a:lumMod val="95000"/>
                </a:schemeClr>
              </a:solidFill>
              <a:ln w="6350"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2800">
                  <a:solidFill>
                    <a:schemeClr val="tx1"/>
                  </a:solidFill>
                </a:endParaRPr>
              </a:p>
            </p:txBody>
          </p:sp>
          <p:sp>
            <p:nvSpPr>
              <p:cNvPr id="70" name="Flecha curvada hacia arriba 69"/>
              <p:cNvSpPr/>
              <p:nvPr/>
            </p:nvSpPr>
            <p:spPr>
              <a:xfrm rot="2096714">
                <a:off x="2576824" y="5132527"/>
                <a:ext cx="246062" cy="96817"/>
              </a:xfrm>
              <a:prstGeom prst="curvedUpArrow">
                <a:avLst/>
              </a:prstGeom>
              <a:solidFill>
                <a:schemeClr val="bg1">
                  <a:lumMod val="95000"/>
                </a:schemeClr>
              </a:solidFill>
              <a:ln w="6350"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2800">
                  <a:solidFill>
                    <a:schemeClr val="tx1"/>
                  </a:solidFill>
                </a:endParaRPr>
              </a:p>
            </p:txBody>
          </p:sp>
          <p:sp>
            <p:nvSpPr>
              <p:cNvPr id="71" name="Flecha curvada hacia arriba 70"/>
              <p:cNvSpPr/>
              <p:nvPr/>
            </p:nvSpPr>
            <p:spPr>
              <a:xfrm rot="3589241">
                <a:off x="2579999" y="3464049"/>
                <a:ext cx="246062" cy="96817"/>
              </a:xfrm>
              <a:prstGeom prst="curvedUpArrow">
                <a:avLst/>
              </a:prstGeom>
              <a:solidFill>
                <a:schemeClr val="bg1">
                  <a:lumMod val="95000"/>
                </a:schemeClr>
              </a:solidFill>
              <a:ln w="6350"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2800">
                  <a:solidFill>
                    <a:schemeClr val="tx1"/>
                  </a:solidFill>
                </a:endParaRPr>
              </a:p>
            </p:txBody>
          </p:sp>
          <p:sp>
            <p:nvSpPr>
              <p:cNvPr id="72" name="Flecha curvada hacia arriba 71"/>
              <p:cNvSpPr/>
              <p:nvPr/>
            </p:nvSpPr>
            <p:spPr>
              <a:xfrm rot="20424417" flipV="1">
                <a:off x="1048493" y="4476866"/>
                <a:ext cx="246062" cy="97211"/>
              </a:xfrm>
              <a:prstGeom prst="curvedUpArrow">
                <a:avLst/>
              </a:prstGeom>
              <a:solidFill>
                <a:schemeClr val="bg1">
                  <a:lumMod val="95000"/>
                </a:schemeClr>
              </a:solidFill>
              <a:ln w="6350"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2800">
                  <a:solidFill>
                    <a:schemeClr val="tx1"/>
                  </a:solidFill>
                </a:endParaRPr>
              </a:p>
            </p:txBody>
          </p:sp>
          <p:sp>
            <p:nvSpPr>
              <p:cNvPr id="73" name="Flecha curvada hacia arriba 72"/>
              <p:cNvSpPr/>
              <p:nvPr/>
            </p:nvSpPr>
            <p:spPr>
              <a:xfrm rot="20424417" flipV="1">
                <a:off x="1011970" y="2754413"/>
                <a:ext cx="246062" cy="97211"/>
              </a:xfrm>
              <a:prstGeom prst="curvedUpArrow">
                <a:avLst/>
              </a:prstGeom>
              <a:solidFill>
                <a:schemeClr val="bg1">
                  <a:lumMod val="95000"/>
                </a:schemeClr>
              </a:solidFill>
              <a:ln w="6350"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2800">
                  <a:solidFill>
                    <a:schemeClr val="tx1"/>
                  </a:solidFill>
                </a:endParaRPr>
              </a:p>
            </p:txBody>
          </p:sp>
          <p:sp>
            <p:nvSpPr>
              <p:cNvPr id="74" name="CuadroTexto 73"/>
              <p:cNvSpPr txBox="1"/>
              <p:nvPr/>
            </p:nvSpPr>
            <p:spPr>
              <a:xfrm>
                <a:off x="1186532" y="2688053"/>
                <a:ext cx="356935" cy="19236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b="1" dirty="0">
                    <a:solidFill>
                      <a:schemeClr val="accent2">
                        <a:lumMod val="75000"/>
                      </a:schemeClr>
                    </a:solidFill>
                  </a:rPr>
                  <a:t>A196</a:t>
                </a:r>
              </a:p>
            </p:txBody>
          </p:sp>
          <p:sp>
            <p:nvSpPr>
              <p:cNvPr id="75" name="Flecha derecha 74"/>
              <p:cNvSpPr/>
              <p:nvPr/>
            </p:nvSpPr>
            <p:spPr>
              <a:xfrm>
                <a:off x="1230247" y="3037206"/>
                <a:ext cx="115129" cy="45719"/>
              </a:xfrm>
              <a:prstGeom prst="rightArrow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2800"/>
              </a:p>
            </p:txBody>
          </p:sp>
          <p:sp>
            <p:nvSpPr>
              <p:cNvPr id="76" name="Flecha derecha 75"/>
              <p:cNvSpPr/>
              <p:nvPr/>
            </p:nvSpPr>
            <p:spPr>
              <a:xfrm>
                <a:off x="1462026" y="3318202"/>
                <a:ext cx="115129" cy="45719"/>
              </a:xfrm>
              <a:prstGeom prst="rightArrow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2800"/>
              </a:p>
            </p:txBody>
          </p:sp>
          <p:sp>
            <p:nvSpPr>
              <p:cNvPr id="77" name="Flecha curvada hacia arriba 76"/>
              <p:cNvSpPr/>
              <p:nvPr/>
            </p:nvSpPr>
            <p:spPr>
              <a:xfrm rot="20424417" flipV="1">
                <a:off x="1940665" y="5151574"/>
                <a:ext cx="246062" cy="97211"/>
              </a:xfrm>
              <a:prstGeom prst="curvedUpArrow">
                <a:avLst/>
              </a:prstGeom>
              <a:solidFill>
                <a:schemeClr val="bg1">
                  <a:lumMod val="95000"/>
                </a:schemeClr>
              </a:solidFill>
              <a:ln w="6350"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2800">
                  <a:solidFill>
                    <a:schemeClr val="tx1"/>
                  </a:solidFill>
                </a:endParaRPr>
              </a:p>
            </p:txBody>
          </p:sp>
          <p:sp>
            <p:nvSpPr>
              <p:cNvPr id="78" name="Flecha derecha 77"/>
              <p:cNvSpPr/>
              <p:nvPr/>
            </p:nvSpPr>
            <p:spPr>
              <a:xfrm rot="5180696">
                <a:off x="2098681" y="3643541"/>
                <a:ext cx="59630" cy="55204"/>
              </a:xfrm>
              <a:prstGeom prst="rightArrow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2800"/>
              </a:p>
            </p:txBody>
          </p:sp>
          <p:sp>
            <p:nvSpPr>
              <p:cNvPr id="79" name="Flecha derecha 78"/>
              <p:cNvSpPr/>
              <p:nvPr/>
            </p:nvSpPr>
            <p:spPr>
              <a:xfrm rot="5180696">
                <a:off x="2046556" y="5396387"/>
                <a:ext cx="59630" cy="55204"/>
              </a:xfrm>
              <a:prstGeom prst="rightArrow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2800"/>
              </a:p>
            </p:txBody>
          </p:sp>
          <p:sp>
            <p:nvSpPr>
              <p:cNvPr id="80" name="Flecha derecha 79"/>
              <p:cNvSpPr/>
              <p:nvPr/>
            </p:nvSpPr>
            <p:spPr>
              <a:xfrm>
                <a:off x="1322321" y="4764422"/>
                <a:ext cx="115129" cy="45719"/>
              </a:xfrm>
              <a:prstGeom prst="rightArrow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2800"/>
              </a:p>
            </p:txBody>
          </p:sp>
          <p:sp>
            <p:nvSpPr>
              <p:cNvPr id="81" name="Flecha derecha 80"/>
              <p:cNvSpPr/>
              <p:nvPr/>
            </p:nvSpPr>
            <p:spPr>
              <a:xfrm>
                <a:off x="1460430" y="5045418"/>
                <a:ext cx="115129" cy="45719"/>
              </a:xfrm>
              <a:prstGeom prst="rightArrow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2800"/>
              </a:p>
            </p:txBody>
          </p:sp>
          <p:sp>
            <p:nvSpPr>
              <p:cNvPr id="82" name="CuadroTexto 81"/>
              <p:cNvSpPr txBox="1"/>
              <p:nvPr/>
            </p:nvSpPr>
            <p:spPr>
              <a:xfrm>
                <a:off x="1382728" y="5720829"/>
                <a:ext cx="453116" cy="19236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b="1" dirty="0">
                    <a:solidFill>
                      <a:srgbClr val="7F6757"/>
                    </a:solidFill>
                  </a:rPr>
                  <a:t>NAD(A)</a:t>
                </a:r>
              </a:p>
            </p:txBody>
          </p:sp>
          <p:sp>
            <p:nvSpPr>
              <p:cNvPr id="83" name="CuadroTexto 82"/>
              <p:cNvSpPr txBox="1"/>
              <p:nvPr/>
            </p:nvSpPr>
            <p:spPr>
              <a:xfrm>
                <a:off x="1803366" y="4332349"/>
                <a:ext cx="507885" cy="19236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b="1" dirty="0">
                    <a:solidFill>
                      <a:srgbClr val="7F6757"/>
                    </a:solidFill>
                  </a:rPr>
                  <a:t>NADH(B)</a:t>
                </a:r>
              </a:p>
            </p:txBody>
          </p:sp>
          <p:sp>
            <p:nvSpPr>
              <p:cNvPr id="84" name="CuadroTexto 83"/>
              <p:cNvSpPr txBox="1"/>
              <p:nvPr/>
            </p:nvSpPr>
            <p:spPr>
              <a:xfrm>
                <a:off x="605634" y="1681200"/>
                <a:ext cx="559982" cy="20518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000" b="1" dirty="0">
                    <a:sym typeface="Symbol" panose="05050102010706020507" pitchFamily="18" charset="2"/>
                  </a:rPr>
                  <a:t></a:t>
                </a:r>
                <a:r>
                  <a:rPr lang="es-ES" sz="1000" b="1" dirty="0"/>
                  <a:t>-</a:t>
                </a:r>
                <a:r>
                  <a:rPr lang="es-ES" sz="1000" b="1" dirty="0" err="1"/>
                  <a:t>hairpin</a:t>
                </a:r>
                <a:endParaRPr lang="es-ES" sz="1000" b="1" dirty="0"/>
              </a:p>
            </p:txBody>
          </p:sp>
          <p:sp>
            <p:nvSpPr>
              <p:cNvPr id="85" name="CuadroTexto 84"/>
              <p:cNvSpPr txBox="1"/>
              <p:nvPr/>
            </p:nvSpPr>
            <p:spPr>
              <a:xfrm>
                <a:off x="1562351" y="1410483"/>
                <a:ext cx="565326" cy="20518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000" b="1" dirty="0">
                    <a:sym typeface="Symbol" panose="05050102010706020507" pitchFamily="18" charset="2"/>
                  </a:rPr>
                  <a:t></a:t>
                </a:r>
                <a:r>
                  <a:rPr lang="es-ES" sz="1000" b="1" dirty="0"/>
                  <a:t>-Central</a:t>
                </a:r>
              </a:p>
            </p:txBody>
          </p:sp>
        </p:grpSp>
        <p:grpSp>
          <p:nvGrpSpPr>
            <p:cNvPr id="3" name="Grupo 2"/>
            <p:cNvGrpSpPr/>
            <p:nvPr/>
          </p:nvGrpSpPr>
          <p:grpSpPr>
            <a:xfrm>
              <a:off x="436852" y="1292136"/>
              <a:ext cx="2394476" cy="2510485"/>
              <a:chOff x="335252" y="1292136"/>
              <a:chExt cx="2394476" cy="2510485"/>
            </a:xfrm>
          </p:grpSpPr>
          <p:grpSp>
            <p:nvGrpSpPr>
              <p:cNvPr id="20" name="Grupo 19"/>
              <p:cNvGrpSpPr/>
              <p:nvPr/>
            </p:nvGrpSpPr>
            <p:grpSpPr>
              <a:xfrm>
                <a:off x="589517" y="1292136"/>
                <a:ext cx="2140211" cy="2510485"/>
                <a:chOff x="71297" y="135125"/>
                <a:chExt cx="3521814" cy="4131116"/>
              </a:xfrm>
            </p:grpSpPr>
            <p:pic>
              <p:nvPicPr>
                <p:cNvPr id="4" name="Imagen 3"/>
                <p:cNvPicPr>
                  <a:picLocks noChangeAspect="1"/>
                </p:cNvPicPr>
                <p:nvPr/>
              </p:nvPicPr>
              <p:blipFill rotWithShape="1"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2456" r="26667"/>
                <a:stretch/>
              </p:blipFill>
              <p:spPr>
                <a:xfrm>
                  <a:off x="103953" y="421727"/>
                  <a:ext cx="3489158" cy="3844514"/>
                </a:xfrm>
                <a:prstGeom prst="rect">
                  <a:avLst/>
                </a:prstGeom>
              </p:spPr>
            </p:pic>
            <p:sp>
              <p:nvSpPr>
                <p:cNvPr id="9" name="CuadroTexto 8"/>
                <p:cNvSpPr txBox="1"/>
                <p:nvPr/>
              </p:nvSpPr>
              <p:spPr>
                <a:xfrm>
                  <a:off x="1289218" y="135125"/>
                  <a:ext cx="1155890" cy="75969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s-ES" sz="1200" b="1" dirty="0" err="1">
                      <a:solidFill>
                        <a:srgbClr val="FF0000"/>
                      </a:solidFill>
                      <a:cs typeface="Arial" panose="020B0604020202020204" pitchFamily="34" charset="0"/>
                    </a:rPr>
                    <a:t>Helix</a:t>
                  </a:r>
                  <a:r>
                    <a:rPr lang="es-ES" sz="1200" b="1" dirty="0">
                      <a:solidFill>
                        <a:srgbClr val="FF0000"/>
                      </a:solidFill>
                      <a:cs typeface="Arial" panose="020B0604020202020204" pitchFamily="34" charset="0"/>
                    </a:rPr>
                    <a:t> </a:t>
                  </a:r>
                </a:p>
                <a:p>
                  <a:pPr algn="ctr"/>
                  <a:r>
                    <a:rPr lang="es-ES" sz="1200" b="1" dirty="0">
                      <a:solidFill>
                        <a:srgbClr val="FF0000"/>
                      </a:solidFill>
                      <a:cs typeface="Arial" panose="020B0604020202020204" pitchFamily="34" charset="0"/>
                    </a:rPr>
                    <a:t>517-524</a:t>
                  </a:r>
                </a:p>
              </p:txBody>
            </p:sp>
            <p:sp>
              <p:nvSpPr>
                <p:cNvPr id="10" name="CuadroTexto 9"/>
                <p:cNvSpPr txBox="1"/>
                <p:nvPr/>
              </p:nvSpPr>
              <p:spPr>
                <a:xfrm>
                  <a:off x="71297" y="2243116"/>
                  <a:ext cx="1155890" cy="75969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s-ES" sz="1200" b="1" dirty="0" err="1">
                      <a:solidFill>
                        <a:srgbClr val="FF0000"/>
                      </a:solidFill>
                      <a:cs typeface="Arial" panose="020B0604020202020204" pitchFamily="34" charset="0"/>
                    </a:rPr>
                    <a:t>Helix</a:t>
                  </a:r>
                  <a:r>
                    <a:rPr lang="es-ES" sz="1200" b="1" dirty="0">
                      <a:solidFill>
                        <a:srgbClr val="FF0000"/>
                      </a:solidFill>
                      <a:cs typeface="Arial" panose="020B0604020202020204" pitchFamily="34" charset="0"/>
                    </a:rPr>
                    <a:t> </a:t>
                  </a:r>
                </a:p>
                <a:p>
                  <a:pPr algn="ctr"/>
                  <a:r>
                    <a:rPr lang="es-ES" sz="1200" b="1" dirty="0">
                      <a:solidFill>
                        <a:srgbClr val="FF0000"/>
                      </a:solidFill>
                      <a:cs typeface="Arial" panose="020B0604020202020204" pitchFamily="34" charset="0"/>
                    </a:rPr>
                    <a:t>529-533</a:t>
                  </a:r>
                </a:p>
              </p:txBody>
            </p:sp>
          </p:grpSp>
          <p:sp>
            <p:nvSpPr>
              <p:cNvPr id="8" name="CuadroTexto 7"/>
              <p:cNvSpPr txBox="1"/>
              <p:nvPr/>
            </p:nvSpPr>
            <p:spPr>
              <a:xfrm>
                <a:off x="427114" y="1333396"/>
                <a:ext cx="33214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en-GB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CuadroTexto 10"/>
              <p:cNvSpPr txBox="1"/>
              <p:nvPr/>
            </p:nvSpPr>
            <p:spPr>
              <a:xfrm>
                <a:off x="335252" y="1860489"/>
                <a:ext cx="45076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00" b="1" dirty="0">
                    <a:cs typeface="Arial" panose="020B0604020202020204" pitchFamily="34" charset="0"/>
                  </a:rPr>
                  <a:t>P545</a:t>
                </a:r>
              </a:p>
            </p:txBody>
          </p:sp>
          <p:sp>
            <p:nvSpPr>
              <p:cNvPr id="24" name="CuadroTexto 23"/>
              <p:cNvSpPr txBox="1"/>
              <p:nvPr/>
            </p:nvSpPr>
            <p:spPr>
              <a:xfrm>
                <a:off x="956778" y="1445298"/>
                <a:ext cx="48923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50" b="1" dirty="0">
                    <a:cs typeface="Arial" panose="020B0604020202020204" pitchFamily="34" charset="0"/>
                  </a:rPr>
                  <a:t>D559</a:t>
                </a:r>
              </a:p>
            </p:txBody>
          </p:sp>
          <p:sp>
            <p:nvSpPr>
              <p:cNvPr id="41" name="Forma libre 40"/>
              <p:cNvSpPr/>
              <p:nvPr/>
            </p:nvSpPr>
            <p:spPr>
              <a:xfrm>
                <a:off x="697254" y="1619159"/>
                <a:ext cx="692974" cy="409043"/>
              </a:xfrm>
              <a:custGeom>
                <a:avLst/>
                <a:gdLst>
                  <a:gd name="connsiteX0" fmla="*/ 34047 w 1113817"/>
                  <a:gd name="connsiteY0" fmla="*/ 663586 h 663586"/>
                  <a:gd name="connsiteX1" fmla="*/ 4864 w 1113817"/>
                  <a:gd name="connsiteY1" fmla="*/ 610084 h 663586"/>
                  <a:gd name="connsiteX2" fmla="*/ 0 w 1113817"/>
                  <a:gd name="connsiteY2" fmla="*/ 595492 h 663586"/>
                  <a:gd name="connsiteX3" fmla="*/ 4864 w 1113817"/>
                  <a:gd name="connsiteY3" fmla="*/ 498215 h 663586"/>
                  <a:gd name="connsiteX4" fmla="*/ 9728 w 1113817"/>
                  <a:gd name="connsiteY4" fmla="*/ 483624 h 663586"/>
                  <a:gd name="connsiteX5" fmla="*/ 29183 w 1113817"/>
                  <a:gd name="connsiteY5" fmla="*/ 449577 h 663586"/>
                  <a:gd name="connsiteX6" fmla="*/ 58366 w 1113817"/>
                  <a:gd name="connsiteY6" fmla="*/ 420394 h 663586"/>
                  <a:gd name="connsiteX7" fmla="*/ 68094 w 1113817"/>
                  <a:gd name="connsiteY7" fmla="*/ 405803 h 663586"/>
                  <a:gd name="connsiteX8" fmla="*/ 97277 w 1113817"/>
                  <a:gd name="connsiteY8" fmla="*/ 386347 h 663586"/>
                  <a:gd name="connsiteX9" fmla="*/ 116732 w 1113817"/>
                  <a:gd name="connsiteY9" fmla="*/ 371756 h 663586"/>
                  <a:gd name="connsiteX10" fmla="*/ 145915 w 1113817"/>
                  <a:gd name="connsiteY10" fmla="*/ 352301 h 663586"/>
                  <a:gd name="connsiteX11" fmla="*/ 184826 w 1113817"/>
                  <a:gd name="connsiteY11" fmla="*/ 327981 h 663586"/>
                  <a:gd name="connsiteX12" fmla="*/ 199417 w 1113817"/>
                  <a:gd name="connsiteY12" fmla="*/ 318254 h 663586"/>
                  <a:gd name="connsiteX13" fmla="*/ 218873 w 1113817"/>
                  <a:gd name="connsiteY13" fmla="*/ 308526 h 663586"/>
                  <a:gd name="connsiteX14" fmla="*/ 233464 w 1113817"/>
                  <a:gd name="connsiteY14" fmla="*/ 293935 h 663586"/>
                  <a:gd name="connsiteX15" fmla="*/ 252920 w 1113817"/>
                  <a:gd name="connsiteY15" fmla="*/ 284207 h 663586"/>
                  <a:gd name="connsiteX16" fmla="*/ 282103 w 1113817"/>
                  <a:gd name="connsiteY16" fmla="*/ 264752 h 663586"/>
                  <a:gd name="connsiteX17" fmla="*/ 296694 w 1113817"/>
                  <a:gd name="connsiteY17" fmla="*/ 245296 h 663586"/>
                  <a:gd name="connsiteX18" fmla="*/ 311286 w 1113817"/>
                  <a:gd name="connsiteY18" fmla="*/ 235569 h 663586"/>
                  <a:gd name="connsiteX19" fmla="*/ 321013 w 1113817"/>
                  <a:gd name="connsiteY19" fmla="*/ 220977 h 663586"/>
                  <a:gd name="connsiteX20" fmla="*/ 335605 w 1113817"/>
                  <a:gd name="connsiteY20" fmla="*/ 206386 h 663586"/>
                  <a:gd name="connsiteX21" fmla="*/ 345332 w 1113817"/>
                  <a:gd name="connsiteY21" fmla="*/ 186930 h 663586"/>
                  <a:gd name="connsiteX22" fmla="*/ 359924 w 1113817"/>
                  <a:gd name="connsiteY22" fmla="*/ 172339 h 663586"/>
                  <a:gd name="connsiteX23" fmla="*/ 379379 w 1113817"/>
                  <a:gd name="connsiteY23" fmla="*/ 143156 h 663586"/>
                  <a:gd name="connsiteX24" fmla="*/ 384243 w 1113817"/>
                  <a:gd name="connsiteY24" fmla="*/ 128564 h 663586"/>
                  <a:gd name="connsiteX25" fmla="*/ 428017 w 1113817"/>
                  <a:gd name="connsiteY25" fmla="*/ 94518 h 663586"/>
                  <a:gd name="connsiteX26" fmla="*/ 466928 w 1113817"/>
                  <a:gd name="connsiteY26" fmla="*/ 70198 h 663586"/>
                  <a:gd name="connsiteX27" fmla="*/ 500975 w 1113817"/>
                  <a:gd name="connsiteY27" fmla="*/ 60471 h 663586"/>
                  <a:gd name="connsiteX28" fmla="*/ 564205 w 1113817"/>
                  <a:gd name="connsiteY28" fmla="*/ 50743 h 663586"/>
                  <a:gd name="connsiteX29" fmla="*/ 661481 w 1113817"/>
                  <a:gd name="connsiteY29" fmla="*/ 36152 h 663586"/>
                  <a:gd name="connsiteX30" fmla="*/ 841443 w 1113817"/>
                  <a:gd name="connsiteY30" fmla="*/ 36152 h 663586"/>
                  <a:gd name="connsiteX31" fmla="*/ 860898 w 1113817"/>
                  <a:gd name="connsiteY31" fmla="*/ 31288 h 663586"/>
                  <a:gd name="connsiteX32" fmla="*/ 890081 w 1113817"/>
                  <a:gd name="connsiteY32" fmla="*/ 26424 h 663586"/>
                  <a:gd name="connsiteX33" fmla="*/ 933856 w 1113817"/>
                  <a:gd name="connsiteY33" fmla="*/ 16696 h 663586"/>
                  <a:gd name="connsiteX34" fmla="*/ 967903 w 1113817"/>
                  <a:gd name="connsiteY34" fmla="*/ 11833 h 663586"/>
                  <a:gd name="connsiteX35" fmla="*/ 1089498 w 1113817"/>
                  <a:gd name="connsiteY35" fmla="*/ 6969 h 663586"/>
                  <a:gd name="connsiteX36" fmla="*/ 1113817 w 1113817"/>
                  <a:gd name="connsiteY36" fmla="*/ 21560 h 66358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</a:cxnLst>
                <a:rect l="l" t="t" r="r" b="b"/>
                <a:pathLst>
                  <a:path w="1113817" h="663586">
                    <a:moveTo>
                      <a:pt x="34047" y="663586"/>
                    </a:moveTo>
                    <a:cubicBezTo>
                      <a:pt x="8187" y="631260"/>
                      <a:pt x="17875" y="649115"/>
                      <a:pt x="4864" y="610084"/>
                    </a:cubicBezTo>
                    <a:lnTo>
                      <a:pt x="0" y="595492"/>
                    </a:lnTo>
                    <a:cubicBezTo>
                      <a:pt x="1621" y="563066"/>
                      <a:pt x="2051" y="530559"/>
                      <a:pt x="4864" y="498215"/>
                    </a:cubicBezTo>
                    <a:cubicBezTo>
                      <a:pt x="5308" y="493107"/>
                      <a:pt x="7708" y="488336"/>
                      <a:pt x="9728" y="483624"/>
                    </a:cubicBezTo>
                    <a:cubicBezTo>
                      <a:pt x="13371" y="475125"/>
                      <a:pt x="22448" y="457154"/>
                      <a:pt x="29183" y="449577"/>
                    </a:cubicBezTo>
                    <a:cubicBezTo>
                      <a:pt x="38323" y="439295"/>
                      <a:pt x="50735" y="431840"/>
                      <a:pt x="58366" y="420394"/>
                    </a:cubicBezTo>
                    <a:cubicBezTo>
                      <a:pt x="61609" y="415530"/>
                      <a:pt x="63695" y="409652"/>
                      <a:pt x="68094" y="405803"/>
                    </a:cubicBezTo>
                    <a:cubicBezTo>
                      <a:pt x="76893" y="398104"/>
                      <a:pt x="87924" y="393362"/>
                      <a:pt x="97277" y="386347"/>
                    </a:cubicBezTo>
                    <a:cubicBezTo>
                      <a:pt x="103762" y="381483"/>
                      <a:pt x="110091" y="376405"/>
                      <a:pt x="116732" y="371756"/>
                    </a:cubicBezTo>
                    <a:cubicBezTo>
                      <a:pt x="126310" y="365052"/>
                      <a:pt x="136562" y="359316"/>
                      <a:pt x="145915" y="352301"/>
                    </a:cubicBezTo>
                    <a:cubicBezTo>
                      <a:pt x="183112" y="324403"/>
                      <a:pt x="147441" y="349344"/>
                      <a:pt x="184826" y="327981"/>
                    </a:cubicBezTo>
                    <a:cubicBezTo>
                      <a:pt x="189901" y="325081"/>
                      <a:pt x="194342" y="321154"/>
                      <a:pt x="199417" y="318254"/>
                    </a:cubicBezTo>
                    <a:cubicBezTo>
                      <a:pt x="205713" y="314657"/>
                      <a:pt x="212973" y="312740"/>
                      <a:pt x="218873" y="308526"/>
                    </a:cubicBezTo>
                    <a:cubicBezTo>
                      <a:pt x="224470" y="304528"/>
                      <a:pt x="227867" y="297933"/>
                      <a:pt x="233464" y="293935"/>
                    </a:cubicBezTo>
                    <a:cubicBezTo>
                      <a:pt x="239364" y="289721"/>
                      <a:pt x="246702" y="287937"/>
                      <a:pt x="252920" y="284207"/>
                    </a:cubicBezTo>
                    <a:cubicBezTo>
                      <a:pt x="262945" y="278192"/>
                      <a:pt x="282103" y="264752"/>
                      <a:pt x="282103" y="264752"/>
                    </a:cubicBezTo>
                    <a:cubicBezTo>
                      <a:pt x="286967" y="258267"/>
                      <a:pt x="290962" y="251028"/>
                      <a:pt x="296694" y="245296"/>
                    </a:cubicBezTo>
                    <a:cubicBezTo>
                      <a:pt x="300827" y="241163"/>
                      <a:pt x="307153" y="239702"/>
                      <a:pt x="311286" y="235569"/>
                    </a:cubicBezTo>
                    <a:cubicBezTo>
                      <a:pt x="315419" y="231436"/>
                      <a:pt x="317271" y="225468"/>
                      <a:pt x="321013" y="220977"/>
                    </a:cubicBezTo>
                    <a:cubicBezTo>
                      <a:pt x="325416" y="215693"/>
                      <a:pt x="330741" y="211250"/>
                      <a:pt x="335605" y="206386"/>
                    </a:cubicBezTo>
                    <a:cubicBezTo>
                      <a:pt x="338847" y="199901"/>
                      <a:pt x="341118" y="192830"/>
                      <a:pt x="345332" y="186930"/>
                    </a:cubicBezTo>
                    <a:cubicBezTo>
                      <a:pt x="349330" y="181333"/>
                      <a:pt x="356108" y="178062"/>
                      <a:pt x="359924" y="172339"/>
                    </a:cubicBezTo>
                    <a:cubicBezTo>
                      <a:pt x="388083" y="130102"/>
                      <a:pt x="332829" y="189706"/>
                      <a:pt x="379379" y="143156"/>
                    </a:cubicBezTo>
                    <a:cubicBezTo>
                      <a:pt x="381000" y="138292"/>
                      <a:pt x="381095" y="132611"/>
                      <a:pt x="384243" y="128564"/>
                    </a:cubicBezTo>
                    <a:cubicBezTo>
                      <a:pt x="407209" y="99036"/>
                      <a:pt x="404043" y="102508"/>
                      <a:pt x="428017" y="94518"/>
                    </a:cubicBezTo>
                    <a:cubicBezTo>
                      <a:pt x="440987" y="86411"/>
                      <a:pt x="452417" y="75034"/>
                      <a:pt x="466928" y="70198"/>
                    </a:cubicBezTo>
                    <a:cubicBezTo>
                      <a:pt x="480831" y="65565"/>
                      <a:pt x="485713" y="63524"/>
                      <a:pt x="500975" y="60471"/>
                    </a:cubicBezTo>
                    <a:cubicBezTo>
                      <a:pt x="522870" y="56092"/>
                      <a:pt x="542013" y="54247"/>
                      <a:pt x="564205" y="50743"/>
                    </a:cubicBezTo>
                    <a:cubicBezTo>
                      <a:pt x="654454" y="36493"/>
                      <a:pt x="590415" y="45034"/>
                      <a:pt x="661481" y="36152"/>
                    </a:cubicBezTo>
                    <a:cubicBezTo>
                      <a:pt x="749545" y="42441"/>
                      <a:pt x="735150" y="44025"/>
                      <a:pt x="841443" y="36152"/>
                    </a:cubicBezTo>
                    <a:cubicBezTo>
                      <a:pt x="848109" y="35658"/>
                      <a:pt x="854343" y="32599"/>
                      <a:pt x="860898" y="31288"/>
                    </a:cubicBezTo>
                    <a:cubicBezTo>
                      <a:pt x="870568" y="29354"/>
                      <a:pt x="880411" y="28358"/>
                      <a:pt x="890081" y="26424"/>
                    </a:cubicBezTo>
                    <a:cubicBezTo>
                      <a:pt x="933779" y="17684"/>
                      <a:pt x="882921" y="25185"/>
                      <a:pt x="933856" y="16696"/>
                    </a:cubicBezTo>
                    <a:cubicBezTo>
                      <a:pt x="945164" y="14811"/>
                      <a:pt x="956554" y="13454"/>
                      <a:pt x="967903" y="11833"/>
                    </a:cubicBezTo>
                    <a:cubicBezTo>
                      <a:pt x="1026350" y="-7650"/>
                      <a:pt x="986846" y="1566"/>
                      <a:pt x="1089498" y="6969"/>
                    </a:cubicBezTo>
                    <a:cubicBezTo>
                      <a:pt x="1112471" y="12712"/>
                      <a:pt x="1105965" y="5854"/>
                      <a:pt x="1113817" y="21560"/>
                    </a:cubicBezTo>
                  </a:path>
                </a:pathLst>
              </a:custGeom>
              <a:ln w="15875" cap="flat" cmpd="sng" algn="ctr">
                <a:solidFill>
                  <a:srgbClr val="FF0000"/>
                </a:solidFill>
                <a:prstDash val="dash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s-ES" sz="2800"/>
              </a:p>
            </p:txBody>
          </p:sp>
          <p:cxnSp>
            <p:nvCxnSpPr>
              <p:cNvPr id="30" name="Conector recto de flecha 29"/>
              <p:cNvCxnSpPr/>
              <p:nvPr/>
            </p:nvCxnSpPr>
            <p:spPr>
              <a:xfrm flipH="1" flipV="1">
                <a:off x="2135302" y="2258272"/>
                <a:ext cx="216099" cy="260476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Conector recto de flecha 36"/>
              <p:cNvCxnSpPr/>
              <p:nvPr/>
            </p:nvCxnSpPr>
            <p:spPr>
              <a:xfrm flipH="1">
                <a:off x="1641859" y="1692385"/>
                <a:ext cx="44592" cy="210829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Conector recto de flecha 41"/>
              <p:cNvCxnSpPr/>
              <p:nvPr/>
            </p:nvCxnSpPr>
            <p:spPr>
              <a:xfrm flipV="1">
                <a:off x="1166033" y="2462542"/>
                <a:ext cx="346059" cy="221539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Conector recto de flecha 44"/>
              <p:cNvCxnSpPr/>
              <p:nvPr/>
            </p:nvCxnSpPr>
            <p:spPr>
              <a:xfrm flipV="1">
                <a:off x="1257052" y="2594696"/>
                <a:ext cx="501637" cy="668189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" name="CuadroTexto 68"/>
              <p:cNvSpPr txBox="1"/>
              <p:nvPr/>
            </p:nvSpPr>
            <p:spPr>
              <a:xfrm>
                <a:off x="828194" y="2952554"/>
                <a:ext cx="43723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200" b="1" dirty="0">
                    <a:ln w="0"/>
                    <a:cs typeface="Arial" panose="020B0604020202020204" pitchFamily="34" charset="0"/>
                  </a:rPr>
                  <a:t>FAD</a:t>
                </a:r>
                <a:endParaRPr lang="es-ES" sz="1200" b="1" dirty="0">
                  <a:cs typeface="Arial" panose="020B0604020202020204" pitchFamily="34" charset="0"/>
                </a:endParaRPr>
              </a:p>
            </p:txBody>
          </p:sp>
          <p:sp>
            <p:nvSpPr>
              <p:cNvPr id="89" name="CuadroTexto 88"/>
              <p:cNvSpPr txBox="1"/>
              <p:nvPr/>
            </p:nvSpPr>
            <p:spPr>
              <a:xfrm>
                <a:off x="2020847" y="2464417"/>
                <a:ext cx="67197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000" b="1" dirty="0">
                    <a:sym typeface="Symbol" panose="05050102010706020507" pitchFamily="18" charset="2"/>
                  </a:rPr>
                  <a:t></a:t>
                </a:r>
                <a:r>
                  <a:rPr lang="es-ES" sz="1000" b="1" dirty="0"/>
                  <a:t>-</a:t>
                </a:r>
                <a:r>
                  <a:rPr lang="es-ES" sz="1000" b="1" dirty="0" err="1"/>
                  <a:t>hairpin</a:t>
                </a:r>
                <a:endParaRPr lang="es-ES" sz="1000" b="1" dirty="0"/>
              </a:p>
            </p:txBody>
          </p:sp>
        </p:grpSp>
        <p:grpSp>
          <p:nvGrpSpPr>
            <p:cNvPr id="6" name="Grupo 5"/>
            <p:cNvGrpSpPr/>
            <p:nvPr/>
          </p:nvGrpSpPr>
          <p:grpSpPr>
            <a:xfrm>
              <a:off x="532931" y="3538402"/>
              <a:ext cx="2418938" cy="2419342"/>
              <a:chOff x="548806" y="3830502"/>
              <a:chExt cx="2418938" cy="2419342"/>
            </a:xfrm>
          </p:grpSpPr>
          <p:pic>
            <p:nvPicPr>
              <p:cNvPr id="12" name="Imagen 11"/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5923" r="28758"/>
              <a:stretch/>
            </p:blipFill>
            <p:spPr>
              <a:xfrm>
                <a:off x="881265" y="3913521"/>
                <a:ext cx="1888742" cy="2336323"/>
              </a:xfrm>
              <a:prstGeom prst="rect">
                <a:avLst/>
              </a:prstGeom>
            </p:spPr>
          </p:pic>
          <p:sp>
            <p:nvSpPr>
              <p:cNvPr id="22" name="CuadroTexto 21"/>
              <p:cNvSpPr txBox="1"/>
              <p:nvPr/>
            </p:nvSpPr>
            <p:spPr>
              <a:xfrm>
                <a:off x="548806" y="3830502"/>
                <a:ext cx="33214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34" name="Forma libre 33"/>
              <p:cNvSpPr/>
              <p:nvPr/>
            </p:nvSpPr>
            <p:spPr>
              <a:xfrm>
                <a:off x="1333980" y="3991112"/>
                <a:ext cx="394828" cy="217260"/>
              </a:xfrm>
              <a:custGeom>
                <a:avLst/>
                <a:gdLst>
                  <a:gd name="connsiteX0" fmla="*/ 175318 w 649706"/>
                  <a:gd name="connsiteY0" fmla="*/ 292196 h 357510"/>
                  <a:gd name="connsiteX1" fmla="*/ 144379 w 649706"/>
                  <a:gd name="connsiteY1" fmla="*/ 299071 h 357510"/>
                  <a:gd name="connsiteX2" fmla="*/ 130629 w 649706"/>
                  <a:gd name="connsiteY2" fmla="*/ 305946 h 357510"/>
                  <a:gd name="connsiteX3" fmla="*/ 61877 w 649706"/>
                  <a:gd name="connsiteY3" fmla="*/ 302509 h 357510"/>
                  <a:gd name="connsiteX4" fmla="*/ 44689 w 649706"/>
                  <a:gd name="connsiteY4" fmla="*/ 285321 h 357510"/>
                  <a:gd name="connsiteX5" fmla="*/ 24064 w 649706"/>
                  <a:gd name="connsiteY5" fmla="*/ 257820 h 357510"/>
                  <a:gd name="connsiteX6" fmla="*/ 17188 w 649706"/>
                  <a:gd name="connsiteY6" fmla="*/ 247507 h 357510"/>
                  <a:gd name="connsiteX7" fmla="*/ 6876 w 649706"/>
                  <a:gd name="connsiteY7" fmla="*/ 216569 h 357510"/>
                  <a:gd name="connsiteX8" fmla="*/ 3438 w 649706"/>
                  <a:gd name="connsiteY8" fmla="*/ 206256 h 357510"/>
                  <a:gd name="connsiteX9" fmla="*/ 0 w 649706"/>
                  <a:gd name="connsiteY9" fmla="*/ 195943 h 357510"/>
                  <a:gd name="connsiteX10" fmla="*/ 10313 w 649706"/>
                  <a:gd name="connsiteY10" fmla="*/ 113441 h 357510"/>
                  <a:gd name="connsiteX11" fmla="*/ 24064 w 649706"/>
                  <a:gd name="connsiteY11" fmla="*/ 96253 h 357510"/>
                  <a:gd name="connsiteX12" fmla="*/ 30939 w 649706"/>
                  <a:gd name="connsiteY12" fmla="*/ 85940 h 357510"/>
                  <a:gd name="connsiteX13" fmla="*/ 41252 w 649706"/>
                  <a:gd name="connsiteY13" fmla="*/ 79065 h 357510"/>
                  <a:gd name="connsiteX14" fmla="*/ 51564 w 649706"/>
                  <a:gd name="connsiteY14" fmla="*/ 68752 h 357510"/>
                  <a:gd name="connsiteX15" fmla="*/ 65315 w 649706"/>
                  <a:gd name="connsiteY15" fmla="*/ 65315 h 357510"/>
                  <a:gd name="connsiteX16" fmla="*/ 85940 w 649706"/>
                  <a:gd name="connsiteY16" fmla="*/ 58439 h 357510"/>
                  <a:gd name="connsiteX17" fmla="*/ 106566 w 649706"/>
                  <a:gd name="connsiteY17" fmla="*/ 51564 h 357510"/>
                  <a:gd name="connsiteX18" fmla="*/ 116879 w 649706"/>
                  <a:gd name="connsiteY18" fmla="*/ 48127 h 357510"/>
                  <a:gd name="connsiteX19" fmla="*/ 144379 w 649706"/>
                  <a:gd name="connsiteY19" fmla="*/ 55002 h 357510"/>
                  <a:gd name="connsiteX20" fmla="*/ 151255 w 649706"/>
                  <a:gd name="connsiteY20" fmla="*/ 65315 h 357510"/>
                  <a:gd name="connsiteX21" fmla="*/ 165005 w 649706"/>
                  <a:gd name="connsiteY21" fmla="*/ 72190 h 357510"/>
                  <a:gd name="connsiteX22" fmla="*/ 195943 w 649706"/>
                  <a:gd name="connsiteY22" fmla="*/ 85940 h 357510"/>
                  <a:gd name="connsiteX23" fmla="*/ 257820 w 649706"/>
                  <a:gd name="connsiteY23" fmla="*/ 82503 h 357510"/>
                  <a:gd name="connsiteX24" fmla="*/ 292196 w 649706"/>
                  <a:gd name="connsiteY24" fmla="*/ 79065 h 357510"/>
                  <a:gd name="connsiteX25" fmla="*/ 312822 w 649706"/>
                  <a:gd name="connsiteY25" fmla="*/ 65315 h 357510"/>
                  <a:gd name="connsiteX26" fmla="*/ 319697 w 649706"/>
                  <a:gd name="connsiteY26" fmla="*/ 58439 h 357510"/>
                  <a:gd name="connsiteX27" fmla="*/ 340322 w 649706"/>
                  <a:gd name="connsiteY27" fmla="*/ 51564 h 357510"/>
                  <a:gd name="connsiteX28" fmla="*/ 360948 w 649706"/>
                  <a:gd name="connsiteY28" fmla="*/ 41252 h 357510"/>
                  <a:gd name="connsiteX29" fmla="*/ 371261 w 649706"/>
                  <a:gd name="connsiteY29" fmla="*/ 30939 h 357510"/>
                  <a:gd name="connsiteX30" fmla="*/ 381573 w 649706"/>
                  <a:gd name="connsiteY30" fmla="*/ 27501 h 357510"/>
                  <a:gd name="connsiteX31" fmla="*/ 395324 w 649706"/>
                  <a:gd name="connsiteY31" fmla="*/ 20626 h 357510"/>
                  <a:gd name="connsiteX32" fmla="*/ 409074 w 649706"/>
                  <a:gd name="connsiteY32" fmla="*/ 17188 h 357510"/>
                  <a:gd name="connsiteX33" fmla="*/ 433137 w 649706"/>
                  <a:gd name="connsiteY33" fmla="*/ 10313 h 357510"/>
                  <a:gd name="connsiteX34" fmla="*/ 450325 w 649706"/>
                  <a:gd name="connsiteY34" fmla="*/ 6876 h 357510"/>
                  <a:gd name="connsiteX35" fmla="*/ 470951 w 649706"/>
                  <a:gd name="connsiteY35" fmla="*/ 0 h 357510"/>
                  <a:gd name="connsiteX36" fmla="*/ 515640 w 649706"/>
                  <a:gd name="connsiteY36" fmla="*/ 10313 h 357510"/>
                  <a:gd name="connsiteX37" fmla="*/ 567203 w 649706"/>
                  <a:gd name="connsiteY37" fmla="*/ 20626 h 357510"/>
                  <a:gd name="connsiteX38" fmla="*/ 584391 w 649706"/>
                  <a:gd name="connsiteY38" fmla="*/ 24064 h 357510"/>
                  <a:gd name="connsiteX39" fmla="*/ 615330 w 649706"/>
                  <a:gd name="connsiteY39" fmla="*/ 41252 h 357510"/>
                  <a:gd name="connsiteX40" fmla="*/ 625643 w 649706"/>
                  <a:gd name="connsiteY40" fmla="*/ 48127 h 357510"/>
                  <a:gd name="connsiteX41" fmla="*/ 642831 w 649706"/>
                  <a:gd name="connsiteY41" fmla="*/ 65315 h 357510"/>
                  <a:gd name="connsiteX42" fmla="*/ 649706 w 649706"/>
                  <a:gd name="connsiteY42" fmla="*/ 89378 h 357510"/>
                  <a:gd name="connsiteX43" fmla="*/ 646268 w 649706"/>
                  <a:gd name="connsiteY43" fmla="*/ 137504 h 357510"/>
                  <a:gd name="connsiteX44" fmla="*/ 635955 w 649706"/>
                  <a:gd name="connsiteY44" fmla="*/ 168442 h 357510"/>
                  <a:gd name="connsiteX45" fmla="*/ 632518 w 649706"/>
                  <a:gd name="connsiteY45" fmla="*/ 178755 h 357510"/>
                  <a:gd name="connsiteX46" fmla="*/ 611892 w 649706"/>
                  <a:gd name="connsiteY46" fmla="*/ 199381 h 357510"/>
                  <a:gd name="connsiteX47" fmla="*/ 605017 w 649706"/>
                  <a:gd name="connsiteY47" fmla="*/ 209694 h 357510"/>
                  <a:gd name="connsiteX48" fmla="*/ 584391 w 649706"/>
                  <a:gd name="connsiteY48" fmla="*/ 223444 h 357510"/>
                  <a:gd name="connsiteX49" fmla="*/ 574079 w 649706"/>
                  <a:gd name="connsiteY49" fmla="*/ 230319 h 357510"/>
                  <a:gd name="connsiteX50" fmla="*/ 546578 w 649706"/>
                  <a:gd name="connsiteY50" fmla="*/ 244070 h 357510"/>
                  <a:gd name="connsiteX51" fmla="*/ 508764 w 649706"/>
                  <a:gd name="connsiteY51" fmla="*/ 257820 h 357510"/>
                  <a:gd name="connsiteX52" fmla="*/ 470951 w 649706"/>
                  <a:gd name="connsiteY52" fmla="*/ 268133 h 357510"/>
                  <a:gd name="connsiteX53" fmla="*/ 460638 w 649706"/>
                  <a:gd name="connsiteY53" fmla="*/ 271570 h 357510"/>
                  <a:gd name="connsiteX54" fmla="*/ 426262 w 649706"/>
                  <a:gd name="connsiteY54" fmla="*/ 278445 h 357510"/>
                  <a:gd name="connsiteX55" fmla="*/ 415949 w 649706"/>
                  <a:gd name="connsiteY55" fmla="*/ 281883 h 357510"/>
                  <a:gd name="connsiteX56" fmla="*/ 398761 w 649706"/>
                  <a:gd name="connsiteY56" fmla="*/ 292196 h 357510"/>
                  <a:gd name="connsiteX57" fmla="*/ 388449 w 649706"/>
                  <a:gd name="connsiteY57" fmla="*/ 295633 h 357510"/>
                  <a:gd name="connsiteX58" fmla="*/ 367823 w 649706"/>
                  <a:gd name="connsiteY58" fmla="*/ 305946 h 357510"/>
                  <a:gd name="connsiteX59" fmla="*/ 347197 w 649706"/>
                  <a:gd name="connsiteY59" fmla="*/ 312821 h 357510"/>
                  <a:gd name="connsiteX60" fmla="*/ 326572 w 649706"/>
                  <a:gd name="connsiteY60" fmla="*/ 330009 h 357510"/>
                  <a:gd name="connsiteX61" fmla="*/ 305946 w 649706"/>
                  <a:gd name="connsiteY61" fmla="*/ 343760 h 357510"/>
                  <a:gd name="connsiteX62" fmla="*/ 305946 w 649706"/>
                  <a:gd name="connsiteY62" fmla="*/ 357510 h 35751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</a:cxnLst>
                <a:rect l="l" t="t" r="r" b="b"/>
                <a:pathLst>
                  <a:path w="649706" h="357510">
                    <a:moveTo>
                      <a:pt x="175318" y="292196"/>
                    </a:moveTo>
                    <a:cubicBezTo>
                      <a:pt x="170644" y="293131"/>
                      <a:pt x="149932" y="296989"/>
                      <a:pt x="144379" y="299071"/>
                    </a:cubicBezTo>
                    <a:cubicBezTo>
                      <a:pt x="139581" y="300870"/>
                      <a:pt x="135212" y="303654"/>
                      <a:pt x="130629" y="305946"/>
                    </a:cubicBezTo>
                    <a:lnTo>
                      <a:pt x="61877" y="302509"/>
                    </a:lnTo>
                    <a:cubicBezTo>
                      <a:pt x="53998" y="300618"/>
                      <a:pt x="50418" y="291050"/>
                      <a:pt x="44689" y="285321"/>
                    </a:cubicBezTo>
                    <a:cubicBezTo>
                      <a:pt x="31974" y="272605"/>
                      <a:pt x="39607" y="281133"/>
                      <a:pt x="24064" y="257820"/>
                    </a:cubicBezTo>
                    <a:lnTo>
                      <a:pt x="17188" y="247507"/>
                    </a:lnTo>
                    <a:lnTo>
                      <a:pt x="6876" y="216569"/>
                    </a:lnTo>
                    <a:lnTo>
                      <a:pt x="3438" y="206256"/>
                    </a:lnTo>
                    <a:lnTo>
                      <a:pt x="0" y="195943"/>
                    </a:lnTo>
                    <a:cubicBezTo>
                      <a:pt x="365" y="189369"/>
                      <a:pt x="-1875" y="131724"/>
                      <a:pt x="10313" y="113441"/>
                    </a:cubicBezTo>
                    <a:cubicBezTo>
                      <a:pt x="31473" y="81699"/>
                      <a:pt x="4470" y="120744"/>
                      <a:pt x="24064" y="96253"/>
                    </a:cubicBezTo>
                    <a:cubicBezTo>
                      <a:pt x="26645" y="93027"/>
                      <a:pt x="28018" y="88861"/>
                      <a:pt x="30939" y="85940"/>
                    </a:cubicBezTo>
                    <a:cubicBezTo>
                      <a:pt x="33860" y="83019"/>
                      <a:pt x="38078" y="81710"/>
                      <a:pt x="41252" y="79065"/>
                    </a:cubicBezTo>
                    <a:cubicBezTo>
                      <a:pt x="44987" y="75953"/>
                      <a:pt x="47343" y="71164"/>
                      <a:pt x="51564" y="68752"/>
                    </a:cubicBezTo>
                    <a:cubicBezTo>
                      <a:pt x="55666" y="66408"/>
                      <a:pt x="60790" y="66673"/>
                      <a:pt x="65315" y="65315"/>
                    </a:cubicBezTo>
                    <a:cubicBezTo>
                      <a:pt x="72256" y="63233"/>
                      <a:pt x="79065" y="60731"/>
                      <a:pt x="85940" y="58439"/>
                    </a:cubicBezTo>
                    <a:lnTo>
                      <a:pt x="106566" y="51564"/>
                    </a:lnTo>
                    <a:lnTo>
                      <a:pt x="116879" y="48127"/>
                    </a:lnTo>
                    <a:cubicBezTo>
                      <a:pt x="117739" y="48299"/>
                      <a:pt x="140853" y="52181"/>
                      <a:pt x="144379" y="55002"/>
                    </a:cubicBezTo>
                    <a:cubicBezTo>
                      <a:pt x="147605" y="57583"/>
                      <a:pt x="148081" y="62670"/>
                      <a:pt x="151255" y="65315"/>
                    </a:cubicBezTo>
                    <a:cubicBezTo>
                      <a:pt x="155192" y="68595"/>
                      <a:pt x="160526" y="69701"/>
                      <a:pt x="165005" y="72190"/>
                    </a:cubicBezTo>
                    <a:cubicBezTo>
                      <a:pt x="189333" y="85706"/>
                      <a:pt x="173527" y="80337"/>
                      <a:pt x="195943" y="85940"/>
                    </a:cubicBezTo>
                    <a:lnTo>
                      <a:pt x="257820" y="82503"/>
                    </a:lnTo>
                    <a:cubicBezTo>
                      <a:pt x="269307" y="81683"/>
                      <a:pt x="281204" y="82500"/>
                      <a:pt x="292196" y="79065"/>
                    </a:cubicBezTo>
                    <a:cubicBezTo>
                      <a:pt x="300083" y="76600"/>
                      <a:pt x="306980" y="71158"/>
                      <a:pt x="312822" y="65315"/>
                    </a:cubicBezTo>
                    <a:cubicBezTo>
                      <a:pt x="315114" y="63023"/>
                      <a:pt x="316798" y="59889"/>
                      <a:pt x="319697" y="58439"/>
                    </a:cubicBezTo>
                    <a:cubicBezTo>
                      <a:pt x="326179" y="55198"/>
                      <a:pt x="334292" y="55584"/>
                      <a:pt x="340322" y="51564"/>
                    </a:cubicBezTo>
                    <a:cubicBezTo>
                      <a:pt x="353650" y="42679"/>
                      <a:pt x="346715" y="45995"/>
                      <a:pt x="360948" y="41252"/>
                    </a:cubicBezTo>
                    <a:cubicBezTo>
                      <a:pt x="364386" y="37814"/>
                      <a:pt x="367216" y="33636"/>
                      <a:pt x="371261" y="30939"/>
                    </a:cubicBezTo>
                    <a:cubicBezTo>
                      <a:pt x="374276" y="28929"/>
                      <a:pt x="378243" y="28928"/>
                      <a:pt x="381573" y="27501"/>
                    </a:cubicBezTo>
                    <a:cubicBezTo>
                      <a:pt x="386283" y="25482"/>
                      <a:pt x="390526" y="22425"/>
                      <a:pt x="395324" y="20626"/>
                    </a:cubicBezTo>
                    <a:cubicBezTo>
                      <a:pt x="399748" y="18967"/>
                      <a:pt x="404531" y="18486"/>
                      <a:pt x="409074" y="17188"/>
                    </a:cubicBezTo>
                    <a:cubicBezTo>
                      <a:pt x="429150" y="11452"/>
                      <a:pt x="408986" y="15680"/>
                      <a:pt x="433137" y="10313"/>
                    </a:cubicBezTo>
                    <a:cubicBezTo>
                      <a:pt x="438841" y="9046"/>
                      <a:pt x="444688" y="8413"/>
                      <a:pt x="450325" y="6876"/>
                    </a:cubicBezTo>
                    <a:cubicBezTo>
                      <a:pt x="457317" y="4969"/>
                      <a:pt x="470951" y="0"/>
                      <a:pt x="470951" y="0"/>
                    </a:cubicBezTo>
                    <a:cubicBezTo>
                      <a:pt x="533841" y="8985"/>
                      <a:pt x="459015" y="-3169"/>
                      <a:pt x="515640" y="10313"/>
                    </a:cubicBezTo>
                    <a:cubicBezTo>
                      <a:pt x="532691" y="14373"/>
                      <a:pt x="550015" y="17188"/>
                      <a:pt x="567203" y="20626"/>
                    </a:cubicBezTo>
                    <a:lnTo>
                      <a:pt x="584391" y="24064"/>
                    </a:lnTo>
                    <a:cubicBezTo>
                      <a:pt x="600811" y="32273"/>
                      <a:pt x="598060" y="30458"/>
                      <a:pt x="615330" y="41252"/>
                    </a:cubicBezTo>
                    <a:cubicBezTo>
                      <a:pt x="618834" y="43442"/>
                      <a:pt x="622534" y="45406"/>
                      <a:pt x="625643" y="48127"/>
                    </a:cubicBezTo>
                    <a:cubicBezTo>
                      <a:pt x="631741" y="53462"/>
                      <a:pt x="642831" y="65315"/>
                      <a:pt x="642831" y="65315"/>
                    </a:cubicBezTo>
                    <a:cubicBezTo>
                      <a:pt x="644452" y="70177"/>
                      <a:pt x="649706" y="85064"/>
                      <a:pt x="649706" y="89378"/>
                    </a:cubicBezTo>
                    <a:cubicBezTo>
                      <a:pt x="649706" y="105461"/>
                      <a:pt x="648654" y="121599"/>
                      <a:pt x="646268" y="137504"/>
                    </a:cubicBezTo>
                    <a:cubicBezTo>
                      <a:pt x="646266" y="137518"/>
                      <a:pt x="637676" y="163279"/>
                      <a:pt x="635955" y="168442"/>
                    </a:cubicBezTo>
                    <a:cubicBezTo>
                      <a:pt x="634809" y="171880"/>
                      <a:pt x="635080" y="176193"/>
                      <a:pt x="632518" y="178755"/>
                    </a:cubicBezTo>
                    <a:cubicBezTo>
                      <a:pt x="625643" y="185630"/>
                      <a:pt x="617285" y="191291"/>
                      <a:pt x="611892" y="199381"/>
                    </a:cubicBezTo>
                    <a:cubicBezTo>
                      <a:pt x="609600" y="202819"/>
                      <a:pt x="608126" y="206973"/>
                      <a:pt x="605017" y="209694"/>
                    </a:cubicBezTo>
                    <a:cubicBezTo>
                      <a:pt x="598798" y="215135"/>
                      <a:pt x="591266" y="218861"/>
                      <a:pt x="584391" y="223444"/>
                    </a:cubicBezTo>
                    <a:cubicBezTo>
                      <a:pt x="580954" y="225736"/>
                      <a:pt x="577000" y="227398"/>
                      <a:pt x="574079" y="230319"/>
                    </a:cubicBezTo>
                    <a:cubicBezTo>
                      <a:pt x="551478" y="252917"/>
                      <a:pt x="593980" y="212470"/>
                      <a:pt x="546578" y="244070"/>
                    </a:cubicBezTo>
                    <a:cubicBezTo>
                      <a:pt x="520653" y="261353"/>
                      <a:pt x="557998" y="238127"/>
                      <a:pt x="508764" y="257820"/>
                    </a:cubicBezTo>
                    <a:cubicBezTo>
                      <a:pt x="477718" y="270238"/>
                      <a:pt x="506006" y="260343"/>
                      <a:pt x="470951" y="268133"/>
                    </a:cubicBezTo>
                    <a:cubicBezTo>
                      <a:pt x="467414" y="268919"/>
                      <a:pt x="464169" y="270755"/>
                      <a:pt x="460638" y="271570"/>
                    </a:cubicBezTo>
                    <a:cubicBezTo>
                      <a:pt x="449252" y="274197"/>
                      <a:pt x="437348" y="274749"/>
                      <a:pt x="426262" y="278445"/>
                    </a:cubicBezTo>
                    <a:cubicBezTo>
                      <a:pt x="422824" y="279591"/>
                      <a:pt x="419190" y="280262"/>
                      <a:pt x="415949" y="281883"/>
                    </a:cubicBezTo>
                    <a:cubicBezTo>
                      <a:pt x="409973" y="284871"/>
                      <a:pt x="404737" y="289208"/>
                      <a:pt x="398761" y="292196"/>
                    </a:cubicBezTo>
                    <a:cubicBezTo>
                      <a:pt x="395520" y="293816"/>
                      <a:pt x="391760" y="294161"/>
                      <a:pt x="388449" y="295633"/>
                    </a:cubicBezTo>
                    <a:cubicBezTo>
                      <a:pt x="381425" y="298755"/>
                      <a:pt x="374919" y="302990"/>
                      <a:pt x="367823" y="305946"/>
                    </a:cubicBezTo>
                    <a:cubicBezTo>
                      <a:pt x="361133" y="308733"/>
                      <a:pt x="347197" y="312821"/>
                      <a:pt x="347197" y="312821"/>
                    </a:cubicBezTo>
                    <a:cubicBezTo>
                      <a:pt x="337715" y="322304"/>
                      <a:pt x="337742" y="323626"/>
                      <a:pt x="326572" y="330009"/>
                    </a:cubicBezTo>
                    <a:cubicBezTo>
                      <a:pt x="323106" y="331990"/>
                      <a:pt x="308108" y="337275"/>
                      <a:pt x="305946" y="343760"/>
                    </a:cubicBezTo>
                    <a:cubicBezTo>
                      <a:pt x="304496" y="348108"/>
                      <a:pt x="305946" y="352927"/>
                      <a:pt x="305946" y="357510"/>
                    </a:cubicBezTo>
                  </a:path>
                </a:pathLst>
              </a:custGeom>
              <a:ln w="15875" cap="flat" cmpd="sng" algn="ctr">
                <a:solidFill>
                  <a:srgbClr val="FF9999"/>
                </a:solidFill>
                <a:prstDash val="dash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s-ES" sz="2800"/>
              </a:p>
            </p:txBody>
          </p:sp>
          <p:sp>
            <p:nvSpPr>
              <p:cNvPr id="39" name="CuadroTexto 38"/>
              <p:cNvSpPr txBox="1"/>
              <p:nvPr/>
            </p:nvSpPr>
            <p:spPr>
              <a:xfrm>
                <a:off x="1483268" y="4102347"/>
                <a:ext cx="48923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50" b="1" dirty="0">
                    <a:cs typeface="Arial" panose="020B0604020202020204" pitchFamily="34" charset="0"/>
                  </a:rPr>
                  <a:t>D559</a:t>
                </a:r>
              </a:p>
            </p:txBody>
          </p:sp>
          <p:sp>
            <p:nvSpPr>
              <p:cNvPr id="40" name="CuadroTexto 39"/>
              <p:cNvSpPr txBox="1"/>
              <p:nvPr/>
            </p:nvSpPr>
            <p:spPr>
              <a:xfrm>
                <a:off x="966578" y="4018609"/>
                <a:ext cx="48603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50" b="1" dirty="0">
                    <a:cs typeface="Arial" panose="020B0604020202020204" pitchFamily="34" charset="0"/>
                  </a:rPr>
                  <a:t>A511</a:t>
                </a:r>
              </a:p>
            </p:txBody>
          </p:sp>
          <p:cxnSp>
            <p:nvCxnSpPr>
              <p:cNvPr id="31" name="Conector recto de flecha 30"/>
              <p:cNvCxnSpPr/>
              <p:nvPr/>
            </p:nvCxnSpPr>
            <p:spPr>
              <a:xfrm flipH="1" flipV="1">
                <a:off x="2257142" y="4796006"/>
                <a:ext cx="347500" cy="20295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0" name="CuadroTexto 89"/>
              <p:cNvSpPr txBox="1"/>
              <p:nvPr/>
            </p:nvSpPr>
            <p:spPr>
              <a:xfrm>
                <a:off x="2295765" y="4988811"/>
                <a:ext cx="67197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000" b="1" dirty="0">
                    <a:sym typeface="Symbol" panose="05050102010706020507" pitchFamily="18" charset="2"/>
                  </a:rPr>
                  <a:t></a:t>
                </a:r>
                <a:r>
                  <a:rPr lang="es-ES" sz="1000" b="1" dirty="0"/>
                  <a:t>-</a:t>
                </a:r>
                <a:r>
                  <a:rPr lang="es-ES" sz="1000" b="1" dirty="0" err="1"/>
                  <a:t>hairpin</a:t>
                </a:r>
                <a:endParaRPr lang="es-ES" sz="1000" b="1" dirty="0"/>
              </a:p>
            </p:txBody>
          </p:sp>
        </p:grpSp>
        <p:sp>
          <p:nvSpPr>
            <p:cNvPr id="92" name="CuadroTexto 91"/>
            <p:cNvSpPr txBox="1"/>
            <p:nvPr/>
          </p:nvSpPr>
          <p:spPr>
            <a:xfrm>
              <a:off x="3055284" y="1333396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en-GB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CuadroTexto 92"/>
            <p:cNvSpPr txBox="1"/>
            <p:nvPr/>
          </p:nvSpPr>
          <p:spPr>
            <a:xfrm>
              <a:off x="3055284" y="3498746"/>
              <a:ext cx="32092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en-GB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CuadroTexto 93"/>
            <p:cNvSpPr txBox="1"/>
            <p:nvPr/>
          </p:nvSpPr>
          <p:spPr>
            <a:xfrm>
              <a:off x="3055284" y="5568846"/>
              <a:ext cx="30970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en-GB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7" name="Grupo 16"/>
            <p:cNvGrpSpPr/>
            <p:nvPr/>
          </p:nvGrpSpPr>
          <p:grpSpPr>
            <a:xfrm>
              <a:off x="564333" y="5583466"/>
              <a:ext cx="2385865" cy="2449776"/>
              <a:chOff x="638113" y="6907517"/>
              <a:chExt cx="2385865" cy="2449776"/>
            </a:xfrm>
          </p:grpSpPr>
          <p:grpSp>
            <p:nvGrpSpPr>
              <p:cNvPr id="13" name="Grupo 12"/>
              <p:cNvGrpSpPr/>
              <p:nvPr/>
            </p:nvGrpSpPr>
            <p:grpSpPr>
              <a:xfrm>
                <a:off x="638113" y="6907517"/>
                <a:ext cx="2385865" cy="2449776"/>
                <a:chOff x="654015" y="6066183"/>
                <a:chExt cx="2385865" cy="2449776"/>
              </a:xfrm>
            </p:grpSpPr>
            <p:grpSp>
              <p:nvGrpSpPr>
                <p:cNvPr id="21" name="Grupo 20"/>
                <p:cNvGrpSpPr/>
                <p:nvPr/>
              </p:nvGrpSpPr>
              <p:grpSpPr>
                <a:xfrm>
                  <a:off x="654015" y="6066183"/>
                  <a:ext cx="2338053" cy="2449776"/>
                  <a:chOff x="2974538" y="197092"/>
                  <a:chExt cx="3847366" cy="4031217"/>
                </a:xfrm>
              </p:grpSpPr>
              <p:pic>
                <p:nvPicPr>
                  <p:cNvPr id="5" name="Imagen 4"/>
                  <p:cNvPicPr>
                    <a:picLocks noChangeAspect="1"/>
                  </p:cNvPicPr>
                  <p:nvPr/>
                </p:nvPicPr>
                <p:blipFill rotWithShape="1">
                  <a:blip r:embed="rId8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4386" r="25088"/>
                  <a:stretch/>
                </p:blipFill>
                <p:spPr>
                  <a:xfrm>
                    <a:off x="3356809" y="383795"/>
                    <a:ext cx="3465095" cy="3844514"/>
                  </a:xfrm>
                  <a:prstGeom prst="rect">
                    <a:avLst/>
                  </a:prstGeom>
                </p:spPr>
              </p:pic>
              <p:sp>
                <p:nvSpPr>
                  <p:cNvPr id="7" name="CuadroTexto 6"/>
                  <p:cNvSpPr txBox="1"/>
                  <p:nvPr/>
                </p:nvSpPr>
                <p:spPr>
                  <a:xfrm>
                    <a:off x="2974538" y="197092"/>
                    <a:ext cx="546554" cy="55710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</a:p>
                </p:txBody>
              </p:sp>
            </p:grpSp>
            <p:cxnSp>
              <p:nvCxnSpPr>
                <p:cNvPr id="36" name="Conector recto de flecha 35"/>
                <p:cNvCxnSpPr/>
                <p:nvPr/>
              </p:nvCxnSpPr>
              <p:spPr>
                <a:xfrm flipH="1" flipV="1">
                  <a:off x="2307655" y="7013242"/>
                  <a:ext cx="347500" cy="20295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1" name="CuadroTexto 90"/>
                <p:cNvSpPr txBox="1"/>
                <p:nvPr/>
              </p:nvSpPr>
              <p:spPr>
                <a:xfrm>
                  <a:off x="2367901" y="7182217"/>
                  <a:ext cx="67197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s-ES" sz="1000" b="1" dirty="0">
                      <a:sym typeface="Symbol" panose="05050102010706020507" pitchFamily="18" charset="2"/>
                    </a:rPr>
                    <a:t></a:t>
                  </a:r>
                  <a:r>
                    <a:rPr lang="es-ES" sz="1000" b="1" dirty="0"/>
                    <a:t>-</a:t>
                  </a:r>
                  <a:r>
                    <a:rPr lang="es-ES" sz="1000" b="1" dirty="0" err="1"/>
                    <a:t>hairpin</a:t>
                  </a:r>
                  <a:endParaRPr lang="es-ES" sz="1000" b="1" dirty="0"/>
                </a:p>
              </p:txBody>
            </p:sp>
          </p:grpSp>
          <p:sp>
            <p:nvSpPr>
              <p:cNvPr id="25" name="CuadroTexto 24"/>
              <p:cNvSpPr txBox="1"/>
              <p:nvPr/>
            </p:nvSpPr>
            <p:spPr>
              <a:xfrm>
                <a:off x="902191" y="7242103"/>
                <a:ext cx="45236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00" b="1" dirty="0">
                    <a:cs typeface="Arial" panose="020B0604020202020204" pitchFamily="34" charset="0"/>
                  </a:rPr>
                  <a:t>K518</a:t>
                </a:r>
              </a:p>
            </p:txBody>
          </p:sp>
          <p:sp>
            <p:nvSpPr>
              <p:cNvPr id="26" name="CuadroTexto 25"/>
              <p:cNvSpPr txBox="1"/>
              <p:nvPr/>
            </p:nvSpPr>
            <p:spPr>
              <a:xfrm>
                <a:off x="1475769" y="7090724"/>
                <a:ext cx="45076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00" b="1" dirty="0">
                    <a:cs typeface="Arial" panose="020B0604020202020204" pitchFamily="34" charset="0"/>
                  </a:rPr>
                  <a:t>P551</a:t>
                </a:r>
              </a:p>
            </p:txBody>
          </p:sp>
          <p:sp>
            <p:nvSpPr>
              <p:cNvPr id="38" name="Forma libre 37"/>
              <p:cNvSpPr/>
              <p:nvPr/>
            </p:nvSpPr>
            <p:spPr>
              <a:xfrm>
                <a:off x="1203168" y="7093783"/>
                <a:ext cx="371913" cy="212238"/>
              </a:xfrm>
              <a:custGeom>
                <a:avLst/>
                <a:gdLst>
                  <a:gd name="connsiteX0" fmla="*/ 285320 w 625642"/>
                  <a:gd name="connsiteY0" fmla="*/ 491575 h 491575"/>
                  <a:gd name="connsiteX1" fmla="*/ 261257 w 625642"/>
                  <a:gd name="connsiteY1" fmla="*/ 484700 h 491575"/>
                  <a:gd name="connsiteX2" fmla="*/ 226881 w 625642"/>
                  <a:gd name="connsiteY2" fmla="*/ 474388 h 491575"/>
                  <a:gd name="connsiteX3" fmla="*/ 189068 w 625642"/>
                  <a:gd name="connsiteY3" fmla="*/ 470950 h 491575"/>
                  <a:gd name="connsiteX4" fmla="*/ 168442 w 625642"/>
                  <a:gd name="connsiteY4" fmla="*/ 467512 h 491575"/>
                  <a:gd name="connsiteX5" fmla="*/ 120316 w 625642"/>
                  <a:gd name="connsiteY5" fmla="*/ 457200 h 491575"/>
                  <a:gd name="connsiteX6" fmla="*/ 79065 w 625642"/>
                  <a:gd name="connsiteY6" fmla="*/ 443449 h 491575"/>
                  <a:gd name="connsiteX7" fmla="*/ 61877 w 625642"/>
                  <a:gd name="connsiteY7" fmla="*/ 440012 h 491575"/>
                  <a:gd name="connsiteX8" fmla="*/ 37814 w 625642"/>
                  <a:gd name="connsiteY8" fmla="*/ 429699 h 491575"/>
                  <a:gd name="connsiteX9" fmla="*/ 17188 w 625642"/>
                  <a:gd name="connsiteY9" fmla="*/ 422824 h 491575"/>
                  <a:gd name="connsiteX10" fmla="*/ 10313 w 625642"/>
                  <a:gd name="connsiteY10" fmla="*/ 412511 h 491575"/>
                  <a:gd name="connsiteX11" fmla="*/ 6875 w 625642"/>
                  <a:gd name="connsiteY11" fmla="*/ 398760 h 491575"/>
                  <a:gd name="connsiteX12" fmla="*/ 0 w 625642"/>
                  <a:gd name="connsiteY12" fmla="*/ 367822 h 491575"/>
                  <a:gd name="connsiteX13" fmla="*/ 10313 w 625642"/>
                  <a:gd name="connsiteY13" fmla="*/ 281882 h 491575"/>
                  <a:gd name="connsiteX14" fmla="*/ 24063 w 625642"/>
                  <a:gd name="connsiteY14" fmla="*/ 261257 h 491575"/>
                  <a:gd name="connsiteX15" fmla="*/ 30938 w 625642"/>
                  <a:gd name="connsiteY15" fmla="*/ 250944 h 491575"/>
                  <a:gd name="connsiteX16" fmla="*/ 48126 w 625642"/>
                  <a:gd name="connsiteY16" fmla="*/ 237194 h 491575"/>
                  <a:gd name="connsiteX17" fmla="*/ 58439 w 625642"/>
                  <a:gd name="connsiteY17" fmla="*/ 233756 h 491575"/>
                  <a:gd name="connsiteX18" fmla="*/ 99690 w 625642"/>
                  <a:gd name="connsiteY18" fmla="*/ 247506 h 491575"/>
                  <a:gd name="connsiteX19" fmla="*/ 120316 w 625642"/>
                  <a:gd name="connsiteY19" fmla="*/ 254381 h 491575"/>
                  <a:gd name="connsiteX20" fmla="*/ 144379 w 625642"/>
                  <a:gd name="connsiteY20" fmla="*/ 261257 h 491575"/>
                  <a:gd name="connsiteX21" fmla="*/ 154692 w 625642"/>
                  <a:gd name="connsiteY21" fmla="*/ 268132 h 491575"/>
                  <a:gd name="connsiteX22" fmla="*/ 168442 w 625642"/>
                  <a:gd name="connsiteY22" fmla="*/ 275007 h 491575"/>
                  <a:gd name="connsiteX23" fmla="*/ 185630 w 625642"/>
                  <a:gd name="connsiteY23" fmla="*/ 285320 h 491575"/>
                  <a:gd name="connsiteX24" fmla="*/ 195943 w 625642"/>
                  <a:gd name="connsiteY24" fmla="*/ 292195 h 491575"/>
                  <a:gd name="connsiteX25" fmla="*/ 206256 w 625642"/>
                  <a:gd name="connsiteY25" fmla="*/ 295633 h 491575"/>
                  <a:gd name="connsiteX26" fmla="*/ 220006 w 625642"/>
                  <a:gd name="connsiteY26" fmla="*/ 292195 h 491575"/>
                  <a:gd name="connsiteX27" fmla="*/ 237194 w 625642"/>
                  <a:gd name="connsiteY27" fmla="*/ 271569 h 491575"/>
                  <a:gd name="connsiteX28" fmla="*/ 247507 w 625642"/>
                  <a:gd name="connsiteY28" fmla="*/ 257819 h 491575"/>
                  <a:gd name="connsiteX29" fmla="*/ 254382 w 625642"/>
                  <a:gd name="connsiteY29" fmla="*/ 237194 h 491575"/>
                  <a:gd name="connsiteX30" fmla="*/ 261257 w 625642"/>
                  <a:gd name="connsiteY30" fmla="*/ 223443 h 491575"/>
                  <a:gd name="connsiteX31" fmla="*/ 271570 w 625642"/>
                  <a:gd name="connsiteY31" fmla="*/ 185630 h 491575"/>
                  <a:gd name="connsiteX32" fmla="*/ 278445 w 625642"/>
                  <a:gd name="connsiteY32" fmla="*/ 168442 h 491575"/>
                  <a:gd name="connsiteX33" fmla="*/ 281883 w 625642"/>
                  <a:gd name="connsiteY33" fmla="*/ 140941 h 491575"/>
                  <a:gd name="connsiteX34" fmla="*/ 285320 w 625642"/>
                  <a:gd name="connsiteY34" fmla="*/ 120315 h 491575"/>
                  <a:gd name="connsiteX35" fmla="*/ 288758 w 625642"/>
                  <a:gd name="connsiteY35" fmla="*/ 89377 h 491575"/>
                  <a:gd name="connsiteX36" fmla="*/ 295633 w 625642"/>
                  <a:gd name="connsiteY36" fmla="*/ 55001 h 491575"/>
                  <a:gd name="connsiteX37" fmla="*/ 299071 w 625642"/>
                  <a:gd name="connsiteY37" fmla="*/ 44688 h 491575"/>
                  <a:gd name="connsiteX38" fmla="*/ 309384 w 625642"/>
                  <a:gd name="connsiteY38" fmla="*/ 37813 h 491575"/>
                  <a:gd name="connsiteX39" fmla="*/ 316259 w 625642"/>
                  <a:gd name="connsiteY39" fmla="*/ 24063 h 491575"/>
                  <a:gd name="connsiteX40" fmla="*/ 326572 w 625642"/>
                  <a:gd name="connsiteY40" fmla="*/ 20625 h 491575"/>
                  <a:gd name="connsiteX41" fmla="*/ 336884 w 625642"/>
                  <a:gd name="connsiteY41" fmla="*/ 13750 h 491575"/>
                  <a:gd name="connsiteX42" fmla="*/ 360947 w 625642"/>
                  <a:gd name="connsiteY42" fmla="*/ 6875 h 491575"/>
                  <a:gd name="connsiteX43" fmla="*/ 385011 w 625642"/>
                  <a:gd name="connsiteY43" fmla="*/ 0 h 491575"/>
                  <a:gd name="connsiteX44" fmla="*/ 446887 w 625642"/>
                  <a:gd name="connsiteY44" fmla="*/ 6875 h 491575"/>
                  <a:gd name="connsiteX45" fmla="*/ 460638 w 625642"/>
                  <a:gd name="connsiteY45" fmla="*/ 13750 h 491575"/>
                  <a:gd name="connsiteX46" fmla="*/ 470950 w 625642"/>
                  <a:gd name="connsiteY46" fmla="*/ 20625 h 491575"/>
                  <a:gd name="connsiteX47" fmla="*/ 488138 w 625642"/>
                  <a:gd name="connsiteY47" fmla="*/ 24063 h 491575"/>
                  <a:gd name="connsiteX48" fmla="*/ 495014 w 625642"/>
                  <a:gd name="connsiteY48" fmla="*/ 30938 h 491575"/>
                  <a:gd name="connsiteX49" fmla="*/ 508764 w 625642"/>
                  <a:gd name="connsiteY49" fmla="*/ 61876 h 491575"/>
                  <a:gd name="connsiteX50" fmla="*/ 515639 w 625642"/>
                  <a:gd name="connsiteY50" fmla="*/ 72189 h 491575"/>
                  <a:gd name="connsiteX51" fmla="*/ 519077 w 625642"/>
                  <a:gd name="connsiteY51" fmla="*/ 85939 h 491575"/>
                  <a:gd name="connsiteX52" fmla="*/ 522514 w 625642"/>
                  <a:gd name="connsiteY52" fmla="*/ 96252 h 491575"/>
                  <a:gd name="connsiteX53" fmla="*/ 529390 w 625642"/>
                  <a:gd name="connsiteY53" fmla="*/ 123753 h 491575"/>
                  <a:gd name="connsiteX54" fmla="*/ 536265 w 625642"/>
                  <a:gd name="connsiteY54" fmla="*/ 192505 h 491575"/>
                  <a:gd name="connsiteX55" fmla="*/ 543140 w 625642"/>
                  <a:gd name="connsiteY55" fmla="*/ 216568 h 491575"/>
                  <a:gd name="connsiteX56" fmla="*/ 556890 w 625642"/>
                  <a:gd name="connsiteY56" fmla="*/ 220006 h 491575"/>
                  <a:gd name="connsiteX57" fmla="*/ 567203 w 625642"/>
                  <a:gd name="connsiteY57" fmla="*/ 223443 h 491575"/>
                  <a:gd name="connsiteX58" fmla="*/ 594704 w 625642"/>
                  <a:gd name="connsiteY58" fmla="*/ 230318 h 491575"/>
                  <a:gd name="connsiteX59" fmla="*/ 618767 w 625642"/>
                  <a:gd name="connsiteY59" fmla="*/ 237194 h 491575"/>
                  <a:gd name="connsiteX60" fmla="*/ 625642 w 625642"/>
                  <a:gd name="connsiteY60" fmla="*/ 244069 h 49157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</a:cxnLst>
                <a:rect l="l" t="t" r="r" b="b"/>
                <a:pathLst>
                  <a:path w="625642" h="491575">
                    <a:moveTo>
                      <a:pt x="285320" y="491575"/>
                    </a:moveTo>
                    <a:cubicBezTo>
                      <a:pt x="277299" y="489283"/>
                      <a:pt x="269230" y="487153"/>
                      <a:pt x="261257" y="484700"/>
                    </a:cubicBezTo>
                    <a:cubicBezTo>
                      <a:pt x="253776" y="482398"/>
                      <a:pt x="236171" y="475627"/>
                      <a:pt x="226881" y="474388"/>
                    </a:cubicBezTo>
                    <a:cubicBezTo>
                      <a:pt x="214336" y="472715"/>
                      <a:pt x="201638" y="472429"/>
                      <a:pt x="189068" y="470950"/>
                    </a:cubicBezTo>
                    <a:cubicBezTo>
                      <a:pt x="182146" y="470135"/>
                      <a:pt x="175317" y="468658"/>
                      <a:pt x="168442" y="467512"/>
                    </a:cubicBezTo>
                    <a:cubicBezTo>
                      <a:pt x="137791" y="455252"/>
                      <a:pt x="163825" y="463893"/>
                      <a:pt x="120316" y="457200"/>
                    </a:cubicBezTo>
                    <a:cubicBezTo>
                      <a:pt x="104859" y="454822"/>
                      <a:pt x="94845" y="448304"/>
                      <a:pt x="79065" y="443449"/>
                    </a:cubicBezTo>
                    <a:cubicBezTo>
                      <a:pt x="73481" y="441731"/>
                      <a:pt x="67606" y="441158"/>
                      <a:pt x="61877" y="440012"/>
                    </a:cubicBezTo>
                    <a:cubicBezTo>
                      <a:pt x="45515" y="429103"/>
                      <a:pt x="57994" y="435753"/>
                      <a:pt x="37814" y="429699"/>
                    </a:cubicBezTo>
                    <a:cubicBezTo>
                      <a:pt x="30872" y="427617"/>
                      <a:pt x="17188" y="422824"/>
                      <a:pt x="17188" y="422824"/>
                    </a:cubicBezTo>
                    <a:cubicBezTo>
                      <a:pt x="14896" y="419386"/>
                      <a:pt x="11940" y="416308"/>
                      <a:pt x="10313" y="412511"/>
                    </a:cubicBezTo>
                    <a:cubicBezTo>
                      <a:pt x="8452" y="408168"/>
                      <a:pt x="8173" y="403303"/>
                      <a:pt x="6875" y="398760"/>
                    </a:cubicBezTo>
                    <a:cubicBezTo>
                      <a:pt x="106" y="375068"/>
                      <a:pt x="6204" y="405041"/>
                      <a:pt x="0" y="367822"/>
                    </a:cubicBezTo>
                    <a:cubicBezTo>
                      <a:pt x="126" y="365681"/>
                      <a:pt x="578" y="296484"/>
                      <a:pt x="10313" y="281882"/>
                    </a:cubicBezTo>
                    <a:lnTo>
                      <a:pt x="24063" y="261257"/>
                    </a:lnTo>
                    <a:cubicBezTo>
                      <a:pt x="26355" y="257819"/>
                      <a:pt x="28016" y="253865"/>
                      <a:pt x="30938" y="250944"/>
                    </a:cubicBezTo>
                    <a:cubicBezTo>
                      <a:pt x="37332" y="244551"/>
                      <a:pt x="39455" y="241530"/>
                      <a:pt x="48126" y="237194"/>
                    </a:cubicBezTo>
                    <a:cubicBezTo>
                      <a:pt x="51367" y="235573"/>
                      <a:pt x="55001" y="234902"/>
                      <a:pt x="58439" y="233756"/>
                    </a:cubicBezTo>
                    <a:cubicBezTo>
                      <a:pt x="88877" y="239844"/>
                      <a:pt x="63248" y="233491"/>
                      <a:pt x="99690" y="247506"/>
                    </a:cubicBezTo>
                    <a:cubicBezTo>
                      <a:pt x="106454" y="250107"/>
                      <a:pt x="113374" y="252298"/>
                      <a:pt x="120316" y="254381"/>
                    </a:cubicBezTo>
                    <a:cubicBezTo>
                      <a:pt x="125824" y="256033"/>
                      <a:pt x="138602" y="258369"/>
                      <a:pt x="144379" y="261257"/>
                    </a:cubicBezTo>
                    <a:cubicBezTo>
                      <a:pt x="148074" y="263105"/>
                      <a:pt x="151105" y="266082"/>
                      <a:pt x="154692" y="268132"/>
                    </a:cubicBezTo>
                    <a:cubicBezTo>
                      <a:pt x="159141" y="270674"/>
                      <a:pt x="163963" y="272518"/>
                      <a:pt x="168442" y="275007"/>
                    </a:cubicBezTo>
                    <a:cubicBezTo>
                      <a:pt x="174283" y="278252"/>
                      <a:pt x="179964" y="281779"/>
                      <a:pt x="185630" y="285320"/>
                    </a:cubicBezTo>
                    <a:cubicBezTo>
                      <a:pt x="189134" y="287510"/>
                      <a:pt x="192248" y="290347"/>
                      <a:pt x="195943" y="292195"/>
                    </a:cubicBezTo>
                    <a:cubicBezTo>
                      <a:pt x="199184" y="293816"/>
                      <a:pt x="202818" y="294487"/>
                      <a:pt x="206256" y="295633"/>
                    </a:cubicBezTo>
                    <a:cubicBezTo>
                      <a:pt x="210839" y="294487"/>
                      <a:pt x="215904" y="294539"/>
                      <a:pt x="220006" y="292195"/>
                    </a:cubicBezTo>
                    <a:cubicBezTo>
                      <a:pt x="227756" y="287766"/>
                      <a:pt x="232283" y="278444"/>
                      <a:pt x="237194" y="271569"/>
                    </a:cubicBezTo>
                    <a:cubicBezTo>
                      <a:pt x="240524" y="266907"/>
                      <a:pt x="244069" y="262402"/>
                      <a:pt x="247507" y="257819"/>
                    </a:cubicBezTo>
                    <a:cubicBezTo>
                      <a:pt x="249799" y="250944"/>
                      <a:pt x="251141" y="243676"/>
                      <a:pt x="254382" y="237194"/>
                    </a:cubicBezTo>
                    <a:cubicBezTo>
                      <a:pt x="256674" y="232610"/>
                      <a:pt x="259354" y="228201"/>
                      <a:pt x="261257" y="223443"/>
                    </a:cubicBezTo>
                    <a:cubicBezTo>
                      <a:pt x="276798" y="184588"/>
                      <a:pt x="261213" y="220153"/>
                      <a:pt x="271570" y="185630"/>
                    </a:cubicBezTo>
                    <a:cubicBezTo>
                      <a:pt x="273343" y="179720"/>
                      <a:pt x="276153" y="174171"/>
                      <a:pt x="278445" y="168442"/>
                    </a:cubicBezTo>
                    <a:cubicBezTo>
                      <a:pt x="279591" y="159275"/>
                      <a:pt x="280577" y="150087"/>
                      <a:pt x="281883" y="140941"/>
                    </a:cubicBezTo>
                    <a:cubicBezTo>
                      <a:pt x="282869" y="134041"/>
                      <a:pt x="284399" y="127224"/>
                      <a:pt x="285320" y="120315"/>
                    </a:cubicBezTo>
                    <a:cubicBezTo>
                      <a:pt x="286691" y="110030"/>
                      <a:pt x="287140" y="99626"/>
                      <a:pt x="288758" y="89377"/>
                    </a:cubicBezTo>
                    <a:cubicBezTo>
                      <a:pt x="290581" y="77834"/>
                      <a:pt x="291937" y="66087"/>
                      <a:pt x="295633" y="55001"/>
                    </a:cubicBezTo>
                    <a:cubicBezTo>
                      <a:pt x="296779" y="51563"/>
                      <a:pt x="296807" y="47518"/>
                      <a:pt x="299071" y="44688"/>
                    </a:cubicBezTo>
                    <a:cubicBezTo>
                      <a:pt x="301652" y="41462"/>
                      <a:pt x="305946" y="40105"/>
                      <a:pt x="309384" y="37813"/>
                    </a:cubicBezTo>
                    <a:cubicBezTo>
                      <a:pt x="311676" y="33230"/>
                      <a:pt x="312636" y="27686"/>
                      <a:pt x="316259" y="24063"/>
                    </a:cubicBezTo>
                    <a:cubicBezTo>
                      <a:pt x="318821" y="21501"/>
                      <a:pt x="323331" y="22246"/>
                      <a:pt x="326572" y="20625"/>
                    </a:cubicBezTo>
                    <a:cubicBezTo>
                      <a:pt x="330267" y="18777"/>
                      <a:pt x="333189" y="15598"/>
                      <a:pt x="336884" y="13750"/>
                    </a:cubicBezTo>
                    <a:cubicBezTo>
                      <a:pt x="342383" y="11001"/>
                      <a:pt x="355801" y="8345"/>
                      <a:pt x="360947" y="6875"/>
                    </a:cubicBezTo>
                    <a:cubicBezTo>
                      <a:pt x="395458" y="-2985"/>
                      <a:pt x="342038" y="10741"/>
                      <a:pt x="385011" y="0"/>
                    </a:cubicBezTo>
                    <a:cubicBezTo>
                      <a:pt x="393201" y="630"/>
                      <a:pt x="431601" y="1780"/>
                      <a:pt x="446887" y="6875"/>
                    </a:cubicBezTo>
                    <a:cubicBezTo>
                      <a:pt x="451749" y="8496"/>
                      <a:pt x="456189" y="11208"/>
                      <a:pt x="460638" y="13750"/>
                    </a:cubicBezTo>
                    <a:cubicBezTo>
                      <a:pt x="464225" y="15800"/>
                      <a:pt x="467082" y="19174"/>
                      <a:pt x="470950" y="20625"/>
                    </a:cubicBezTo>
                    <a:cubicBezTo>
                      <a:pt x="476421" y="22677"/>
                      <a:pt x="482409" y="22917"/>
                      <a:pt x="488138" y="24063"/>
                    </a:cubicBezTo>
                    <a:cubicBezTo>
                      <a:pt x="490430" y="26355"/>
                      <a:pt x="493216" y="28241"/>
                      <a:pt x="495014" y="30938"/>
                    </a:cubicBezTo>
                    <a:cubicBezTo>
                      <a:pt x="502302" y="41870"/>
                      <a:pt x="502811" y="49970"/>
                      <a:pt x="508764" y="61876"/>
                    </a:cubicBezTo>
                    <a:cubicBezTo>
                      <a:pt x="510612" y="65571"/>
                      <a:pt x="513347" y="68751"/>
                      <a:pt x="515639" y="72189"/>
                    </a:cubicBezTo>
                    <a:cubicBezTo>
                      <a:pt x="516785" y="76772"/>
                      <a:pt x="517779" y="81396"/>
                      <a:pt x="519077" y="85939"/>
                    </a:cubicBezTo>
                    <a:cubicBezTo>
                      <a:pt x="520072" y="89423"/>
                      <a:pt x="521561" y="92756"/>
                      <a:pt x="522514" y="96252"/>
                    </a:cubicBezTo>
                    <a:cubicBezTo>
                      <a:pt x="525000" y="105368"/>
                      <a:pt x="529390" y="123753"/>
                      <a:pt x="529390" y="123753"/>
                    </a:cubicBezTo>
                    <a:cubicBezTo>
                      <a:pt x="529952" y="129934"/>
                      <a:pt x="534557" y="183393"/>
                      <a:pt x="536265" y="192505"/>
                    </a:cubicBezTo>
                    <a:cubicBezTo>
                      <a:pt x="537802" y="200704"/>
                      <a:pt x="538135" y="209894"/>
                      <a:pt x="543140" y="216568"/>
                    </a:cubicBezTo>
                    <a:cubicBezTo>
                      <a:pt x="545975" y="220348"/>
                      <a:pt x="552347" y="218708"/>
                      <a:pt x="556890" y="220006"/>
                    </a:cubicBezTo>
                    <a:cubicBezTo>
                      <a:pt x="560374" y="221001"/>
                      <a:pt x="563688" y="222564"/>
                      <a:pt x="567203" y="223443"/>
                    </a:cubicBezTo>
                    <a:cubicBezTo>
                      <a:pt x="625669" y="238059"/>
                      <a:pt x="555452" y="218542"/>
                      <a:pt x="594704" y="230318"/>
                    </a:cubicBezTo>
                    <a:cubicBezTo>
                      <a:pt x="602694" y="232715"/>
                      <a:pt x="611144" y="233806"/>
                      <a:pt x="618767" y="237194"/>
                    </a:cubicBezTo>
                    <a:cubicBezTo>
                      <a:pt x="621729" y="238510"/>
                      <a:pt x="623350" y="241777"/>
                      <a:pt x="625642" y="244069"/>
                    </a:cubicBezTo>
                  </a:path>
                </a:pathLst>
              </a:custGeom>
              <a:ln w="15875" cap="flat" cmpd="sng" algn="ctr">
                <a:solidFill>
                  <a:srgbClr val="FF00FF"/>
                </a:solidFill>
                <a:prstDash val="dash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s-ES" sz="280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02614595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349</TotalTime>
  <Words>77</Words>
  <Application>Microsoft Office PowerPoint</Application>
  <PresentationFormat>A4 (210 x 297 mm)</PresentationFormat>
  <Paragraphs>51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usuario</dc:creator>
  <cp:lastModifiedBy>Patricia</cp:lastModifiedBy>
  <cp:revision>339</cp:revision>
  <cp:lastPrinted>2019-10-25T10:24:34Z</cp:lastPrinted>
  <dcterms:created xsi:type="dcterms:W3CDTF">2018-08-31T11:19:24Z</dcterms:created>
  <dcterms:modified xsi:type="dcterms:W3CDTF">2020-12-15T16:40:26Z</dcterms:modified>
</cp:coreProperties>
</file>